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8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9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10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1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  <p:sldId id="265" r:id="rId3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呼吸器内科" initials="呼吸器内科" lastIdx="1" clrIdx="0">
    <p:extLst>
      <p:ext uri="{19B8F6BF-5375-455C-9EA6-DF929625EA0E}">
        <p15:presenceInfo xmlns:p15="http://schemas.microsoft.com/office/powerpoint/2012/main" userId="呼吸器内科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5383" autoAdjust="0"/>
  </p:normalViewPr>
  <p:slideViewPr>
    <p:cSldViewPr snapToGrid="0" showGuides="1">
      <p:cViewPr varScale="1">
        <p:scale>
          <a:sx n="52" d="100"/>
          <a:sy n="52" d="100"/>
        </p:scale>
        <p:origin x="2316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542;&#25991;&#22519;&#31558;\EM900\BAL&#12289;&#12469;&#12452;&#12488;&#12459;&#12452;&#12531;\supplementary\20190517%20EM24%20MIP-2%20ELIS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542;&#25991;&#22519;&#31558;\EM900\BAL&#12289;&#12469;&#12452;&#12488;&#12459;&#12452;&#12531;\supplementary\20180511%20EM11,%2012&#32113;&#21512;%20IL-5%20ELISA(&#25913;&#22793;)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542;&#25991;&#22519;&#31558;\EM900\BAL&#12289;&#12469;&#12452;&#12488;&#12459;&#12452;&#12531;\supplementary\20180424%20EM11,%2012&#32113;&#21512;%20IL-13%20ELISA(&#25913;&#22793;)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35542;&#25991;&#22519;&#31558;\EM900\BAL&#12289;&#12469;&#12452;&#12488;&#12459;&#12452;&#12531;\supplementary\20180423%20EM11,%2012%20BAL&#32113;&#21512;(&#25913;&#22793;)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542;&#25991;&#22519;&#31558;\EM900\BAL&#12289;&#12469;&#12452;&#12488;&#12459;&#12452;&#12531;\supplementary\20190517%20EM24%20IL-17%20ELIS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542;&#25991;&#22519;&#31558;\EM900\BAL&#12289;&#12469;&#12452;&#12488;&#12459;&#12452;&#12531;\supplementary\20190517%20EM24%20RANTES%20ELIS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542;&#25991;&#22519;&#31558;\EM900\BAL&#12289;&#12469;&#12452;&#12488;&#12459;&#12452;&#12531;\supplementary\20190611%20EM24%20IL-5%20ELIS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542;&#25991;&#22519;&#31558;\EM900\BAL&#12289;&#12469;&#12452;&#12488;&#12459;&#12452;&#12531;\supplementary\20190517%20EM24%20IL-13%20ELIS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35542;&#25991;&#22519;&#31558;\EM900\BAL&#12289;&#12469;&#12452;&#12488;&#12459;&#12452;&#12531;\supplementary\201905014%20EM24%20BAL(&#32113;&#21512;)&#25913;&#22793;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542;&#25991;&#22519;&#31558;\EM900\BAL&#12289;&#12469;&#12452;&#12488;&#12459;&#12452;&#12531;\supplementary\20180424%20EM11,%2012&#32113;&#21512;%20MIP-2%20ELISA(&#25913;&#22793;)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542;&#25991;&#22519;&#31558;\EM900\BAL&#12289;&#12469;&#12452;&#12488;&#12459;&#12452;&#12531;\supplementary\20180424%20EM11,%2012&#32113;&#21512;%20IL-17%20ELISA(&#25913;&#22793;)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542;&#25991;&#22519;&#31558;\EM900\BAL&#12289;&#12469;&#12452;&#12488;&#12459;&#12452;&#12531;\supplementary\20180424%20EM11,%2012&#32113;&#21512;%20RANTES%20ELISA(&#25913;&#22793;)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P-2</a:t>
            </a:r>
            <a:endParaRPr lang="ja-JP" alt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9100854267059831"/>
          <c:y val="8.7712755230304681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C95-44D9-A005-7E4660BE39D0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C95-44D9-A005-7E4660BE39D0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C95-44D9-A005-7E4660BE39D0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EC95-44D9-A005-7E4660BE39D0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51:$J$54</c:f>
                <c:numCache>
                  <c:formatCode>General</c:formatCode>
                  <c:ptCount val="4"/>
                  <c:pt idx="0">
                    <c:v>0.31208122658898674</c:v>
                  </c:pt>
                  <c:pt idx="1">
                    <c:v>20.587901775979397</c:v>
                  </c:pt>
                  <c:pt idx="2">
                    <c:v>22.677860711441244</c:v>
                  </c:pt>
                  <c:pt idx="3">
                    <c:v>15.7519115446952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44:$H$47</c:f>
              <c:strCache>
                <c:ptCount val="4"/>
                <c:pt idx="0">
                  <c:v>control</c:v>
                </c:pt>
                <c:pt idx="1">
                  <c:v>HDM-PBS-placebo</c:v>
                </c:pt>
                <c:pt idx="2">
                  <c:v>HDM-PBS-CAM</c:v>
                </c:pt>
                <c:pt idx="3">
                  <c:v>HDM-PBS-EM900</c:v>
                </c:pt>
              </c:strCache>
            </c:strRef>
          </c:cat>
          <c:val>
            <c:numRef>
              <c:f>Sheet1!$J$44:$J$47</c:f>
              <c:numCache>
                <c:formatCode>0.0_ </c:formatCode>
                <c:ptCount val="4"/>
                <c:pt idx="0" formatCode="0.0">
                  <c:v>43.693693693693696</c:v>
                </c:pt>
                <c:pt idx="1">
                  <c:v>89.279279279279265</c:v>
                </c:pt>
                <c:pt idx="2">
                  <c:v>81.036036036036023</c:v>
                </c:pt>
                <c:pt idx="3">
                  <c:v>91.0810810810810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EC95-44D9-A005-7E4660BE39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55836192"/>
        <c:axId val="955835104"/>
      </c:barChart>
      <c:catAx>
        <c:axId val="95583619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55835104"/>
        <c:crosses val="autoZero"/>
        <c:auto val="1"/>
        <c:lblAlgn val="ctr"/>
        <c:lblOffset val="100"/>
        <c:noMultiLvlLbl val="0"/>
      </c:catAx>
      <c:valAx>
        <c:axId val="95583510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58361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-5</a:t>
            </a:r>
            <a:endParaRPr lang="ja-JP" alt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2909026759429747"/>
          <c:y val="1.754255104606093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2D2D-40AC-906C-3AD75C913999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2D2D-40AC-906C-3AD75C913999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2D2D-40AC-906C-3AD75C913999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51:$J$53</c:f>
                <c:numCache>
                  <c:formatCode>General</c:formatCode>
                  <c:ptCount val="3"/>
                  <c:pt idx="0">
                    <c:v>0.18803281441647651</c:v>
                  </c:pt>
                  <c:pt idx="1">
                    <c:v>9.2865494129951198</c:v>
                  </c:pt>
                  <c:pt idx="2">
                    <c:v>16.0409476029317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44:$H$46</c:f>
              <c:strCache>
                <c:ptCount val="3"/>
                <c:pt idx="0">
                  <c:v>control</c:v>
                </c:pt>
                <c:pt idx="1">
                  <c:v>HDM-PBS</c:v>
                </c:pt>
                <c:pt idx="2">
                  <c:v>HDM-Poly(I:C)</c:v>
                </c:pt>
              </c:strCache>
            </c:strRef>
          </c:cat>
          <c:val>
            <c:numRef>
              <c:f>Sheet1!$J$44:$J$46</c:f>
              <c:numCache>
                <c:formatCode>0.0_ </c:formatCode>
                <c:ptCount val="3"/>
                <c:pt idx="0" formatCode="0.0">
                  <c:v>21.626657196390301</c:v>
                </c:pt>
                <c:pt idx="1">
                  <c:v>37.6</c:v>
                </c:pt>
                <c:pt idx="2">
                  <c:v>47.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2D2D-40AC-906C-3AD75C91399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56584032"/>
        <c:axId val="956575328"/>
      </c:barChart>
      <c:catAx>
        <c:axId val="9565840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56575328"/>
        <c:crosses val="autoZero"/>
        <c:auto val="1"/>
        <c:lblAlgn val="ctr"/>
        <c:lblOffset val="100"/>
        <c:noMultiLvlLbl val="0"/>
      </c:catAx>
      <c:valAx>
        <c:axId val="95657532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6584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-13</a:t>
            </a:r>
            <a:endParaRPr lang="ja-JP" alt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1326899511139997"/>
          <c:y val="9.0256299463294821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8FC-4EA4-A333-8C2501993B35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8FC-4EA4-A333-8C2501993B35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E8FC-4EA4-A333-8C2501993B35}"/>
              </c:ext>
            </c:extLst>
          </c:dPt>
          <c:errBars>
            <c:errBarType val="plus"/>
            <c:errValType val="cust"/>
            <c:noEndCap val="0"/>
            <c:plus>
              <c:numRef>
                <c:f>'[20180424 EM11, 12統合 IL-13 ELISA(改変).xlsx]Sheet1'!$J$51:$J$53</c:f>
                <c:numCache>
                  <c:formatCode>General</c:formatCode>
                  <c:ptCount val="3"/>
                  <c:pt idx="0">
                    <c:v>4.3643578047198295</c:v>
                  </c:pt>
                  <c:pt idx="1">
                    <c:v>115.67292094940572</c:v>
                  </c:pt>
                  <c:pt idx="2">
                    <c:v>103.12453192820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20180424 EM11, 12統合 IL-13 ELISA(改変).xlsx]Sheet1'!$H$44:$H$46</c:f>
              <c:strCache>
                <c:ptCount val="3"/>
                <c:pt idx="0">
                  <c:v>control</c:v>
                </c:pt>
                <c:pt idx="1">
                  <c:v>HDM-PBS</c:v>
                </c:pt>
                <c:pt idx="2">
                  <c:v>HDM-Poly(I:C)</c:v>
                </c:pt>
              </c:strCache>
            </c:strRef>
          </c:cat>
          <c:val>
            <c:numRef>
              <c:f>'[20180424 EM11, 12統合 IL-13 ELISA(改変).xlsx]Sheet1'!$J$44:$J$46</c:f>
              <c:numCache>
                <c:formatCode>0.0_ </c:formatCode>
                <c:ptCount val="3"/>
                <c:pt idx="0" formatCode="0.0">
                  <c:v>203.80952380952382</c:v>
                </c:pt>
                <c:pt idx="1">
                  <c:v>591.06349206349205</c:v>
                </c:pt>
                <c:pt idx="2">
                  <c:v>547.777777777777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E8FC-4EA4-A333-8C2501993B3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56569344"/>
        <c:axId val="956569888"/>
      </c:barChart>
      <c:catAx>
        <c:axId val="95656934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56569888"/>
        <c:crosses val="autoZero"/>
        <c:auto val="1"/>
        <c:lblAlgn val="ctr"/>
        <c:lblOffset val="100"/>
        <c:noMultiLvlLbl val="0"/>
      </c:catAx>
      <c:valAx>
        <c:axId val="95656988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65693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3914764891676675E-2"/>
          <c:y val="5.1400554097404488E-2"/>
          <c:w val="0.89785221762533918"/>
          <c:h val="0.82893919510061242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Sheet2!$B$9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C$10:$G$10</c:f>
                <c:numCache>
                  <c:formatCode>General</c:formatCode>
                  <c:ptCount val="5"/>
                  <c:pt idx="0">
                    <c:v>0.40808495847474358</c:v>
                  </c:pt>
                  <c:pt idx="1">
                    <c:v>0.23115147566044233</c:v>
                  </c:pt>
                  <c:pt idx="2">
                    <c:v>1.0400001602563984E-2</c:v>
                  </c:pt>
                  <c:pt idx="3">
                    <c:v>3.850069263446225E-2</c:v>
                  </c:pt>
                  <c:pt idx="4">
                    <c:v>0.446823814756256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2!$C$9:$G$9</c:f>
              <c:numCache>
                <c:formatCode>0.00_ </c:formatCode>
                <c:ptCount val="5"/>
                <c:pt idx="0">
                  <c:v>4.6766666666666667</c:v>
                </c:pt>
                <c:pt idx="1">
                  <c:v>0.57755999999999996</c:v>
                </c:pt>
                <c:pt idx="2">
                  <c:v>8.8763333333333347E-2</c:v>
                </c:pt>
                <c:pt idx="3">
                  <c:v>9.0866666666666665E-2</c:v>
                </c:pt>
                <c:pt idx="4">
                  <c:v>3.9194766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4E5-410C-B6F5-7EDCC57916F6}"/>
            </c:ext>
          </c:extLst>
        </c:ser>
        <c:ser>
          <c:idx val="0"/>
          <c:order val="1"/>
          <c:tx>
            <c:strRef>
              <c:f>Sheet2!$B$5</c:f>
              <c:strCache>
                <c:ptCount val="1"/>
                <c:pt idx="0">
                  <c:v>HDM-PBS-placebo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C$6:$G$6</c:f>
                <c:numCache>
                  <c:formatCode>General</c:formatCode>
                  <c:ptCount val="5"/>
                  <c:pt idx="0">
                    <c:v>11.491504108108121</c:v>
                  </c:pt>
                  <c:pt idx="1">
                    <c:v>1.2068454973262597</c:v>
                  </c:pt>
                  <c:pt idx="2">
                    <c:v>1.356477895292314</c:v>
                  </c:pt>
                  <c:pt idx="3">
                    <c:v>8.8396027469564444</c:v>
                  </c:pt>
                  <c:pt idx="4">
                    <c:v>5.75463334102761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2!$C$4:$G$4</c:f>
              <c:strCache>
                <c:ptCount val="5"/>
                <c:pt idx="0">
                  <c:v>total cells</c:v>
                </c:pt>
                <c:pt idx="1">
                  <c:v>neutrophils</c:v>
                </c:pt>
                <c:pt idx="2">
                  <c:v>lymphocytes</c:v>
                </c:pt>
                <c:pt idx="3">
                  <c:v>eosiniphils</c:v>
                </c:pt>
                <c:pt idx="4">
                  <c:v>macrophages</c:v>
                </c:pt>
              </c:strCache>
            </c:strRef>
          </c:cat>
          <c:val>
            <c:numRef>
              <c:f>Sheet2!$C$5:$G$5</c:f>
              <c:numCache>
                <c:formatCode>0.00_ </c:formatCode>
                <c:ptCount val="5"/>
                <c:pt idx="0">
                  <c:v>41.06666666666667</c:v>
                </c:pt>
                <c:pt idx="1">
                  <c:v>1.4014416666666669</c:v>
                </c:pt>
                <c:pt idx="2">
                  <c:v>2.4448416666666666</c:v>
                </c:pt>
                <c:pt idx="3">
                  <c:v>28.288700000000002</c:v>
                </c:pt>
                <c:pt idx="4">
                  <c:v>8.931683333333332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4E5-410C-B6F5-7EDCC57916F6}"/>
            </c:ext>
          </c:extLst>
        </c:ser>
        <c:ser>
          <c:idx val="2"/>
          <c:order val="2"/>
          <c:tx>
            <c:strRef>
              <c:f>Sheet2!$B$7</c:f>
              <c:strCache>
                <c:ptCount val="1"/>
                <c:pt idx="0">
                  <c:v>HDM-Poly(I:C)-placebo</c:v>
                </c:pt>
              </c:strCache>
            </c:strRef>
          </c:tx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2-C4E5-410C-B6F5-7EDCC57916F6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C$8:$G$8</c:f>
                <c:numCache>
                  <c:formatCode>General</c:formatCode>
                  <c:ptCount val="5"/>
                  <c:pt idx="0">
                    <c:v>11.718091425939061</c:v>
                  </c:pt>
                  <c:pt idx="1">
                    <c:v>1.0631673711133194</c:v>
                  </c:pt>
                  <c:pt idx="2">
                    <c:v>2.792760696992616</c:v>
                  </c:pt>
                  <c:pt idx="3">
                    <c:v>9.2779832996185014</c:v>
                  </c:pt>
                  <c:pt idx="4">
                    <c:v>1.439391326105126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2!$C$4:$G$4</c:f>
              <c:strCache>
                <c:ptCount val="5"/>
                <c:pt idx="0">
                  <c:v>total cells</c:v>
                </c:pt>
                <c:pt idx="1">
                  <c:v>neutrophils</c:v>
                </c:pt>
                <c:pt idx="2">
                  <c:v>lymphocytes</c:v>
                </c:pt>
                <c:pt idx="3">
                  <c:v>eosiniphils</c:v>
                </c:pt>
                <c:pt idx="4">
                  <c:v>macrophages</c:v>
                </c:pt>
              </c:strCache>
            </c:strRef>
          </c:cat>
          <c:val>
            <c:numRef>
              <c:f>Sheet2!$C$7:$G$7</c:f>
              <c:numCache>
                <c:formatCode>0.00_ </c:formatCode>
                <c:ptCount val="5"/>
                <c:pt idx="0">
                  <c:v>55.916666666666664</c:v>
                </c:pt>
                <c:pt idx="1">
                  <c:v>5.3358499999999998</c:v>
                </c:pt>
                <c:pt idx="2">
                  <c:v>8.0847333333333324</c:v>
                </c:pt>
                <c:pt idx="3">
                  <c:v>34.9876</c:v>
                </c:pt>
                <c:pt idx="4">
                  <c:v>7.508483333333333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C4E5-410C-B6F5-7EDCC57916F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6577504"/>
        <c:axId val="956570976"/>
      </c:barChart>
      <c:catAx>
        <c:axId val="95657750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956570976"/>
        <c:crosses val="autoZero"/>
        <c:auto val="1"/>
        <c:lblAlgn val="ctr"/>
        <c:lblOffset val="100"/>
        <c:noMultiLvlLbl val="0"/>
      </c:catAx>
      <c:valAx>
        <c:axId val="956570976"/>
        <c:scaling>
          <c:orientation val="minMax"/>
          <c:max val="70"/>
        </c:scaling>
        <c:delete val="0"/>
        <c:axPos val="l"/>
        <c:numFmt formatCode="0_ " sourceLinked="0"/>
        <c:majorTickMark val="out"/>
        <c:minorTickMark val="none"/>
        <c:tickLblPos val="nextTo"/>
        <c:txPr>
          <a:bodyPr/>
          <a:lstStyle/>
          <a:p>
            <a:pPr>
              <a:defRPr lang="ja-JP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9565775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-17A</a:t>
            </a:r>
            <a:endParaRPr lang="ja-JP" alt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8989873815249165"/>
          <c:y val="8.7712755230304681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040-4DCB-8D47-25E079317094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040-4DCB-8D47-25E079317094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040-4DCB-8D47-25E079317094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4040-4DCB-8D47-25E079317094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51:$J$54</c:f>
                <c:numCache>
                  <c:formatCode>General</c:formatCode>
                  <c:ptCount val="4"/>
                  <c:pt idx="0">
                    <c:v>3.5529247334746241</c:v>
                  </c:pt>
                  <c:pt idx="1">
                    <c:v>6.3994047342218385</c:v>
                  </c:pt>
                  <c:pt idx="2">
                    <c:v>8.3594827819042354</c:v>
                  </c:pt>
                  <c:pt idx="3">
                    <c:v>17.8923462525676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44:$H$47</c:f>
              <c:strCache>
                <c:ptCount val="4"/>
                <c:pt idx="0">
                  <c:v>control</c:v>
                </c:pt>
                <c:pt idx="1">
                  <c:v>HDM-PBS-placebo</c:v>
                </c:pt>
                <c:pt idx="2">
                  <c:v>HDM-PBS-CAM</c:v>
                </c:pt>
                <c:pt idx="3">
                  <c:v>HDM-PBS-EM900</c:v>
                </c:pt>
              </c:strCache>
            </c:strRef>
          </c:cat>
          <c:val>
            <c:numRef>
              <c:f>Sheet1!$J$44:$J$47</c:f>
              <c:numCache>
                <c:formatCode>0.0_ </c:formatCode>
                <c:ptCount val="4"/>
                <c:pt idx="0" formatCode="0.0">
                  <c:v>38.717948717948723</c:v>
                </c:pt>
                <c:pt idx="1">
                  <c:v>73.333333333333329</c:v>
                </c:pt>
                <c:pt idx="2">
                  <c:v>72.738095238095227</c:v>
                </c:pt>
                <c:pt idx="3">
                  <c:v>73.3333333333333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4040-4DCB-8D47-25E0793170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55829120"/>
        <c:axId val="955841088"/>
      </c:barChart>
      <c:catAx>
        <c:axId val="95582912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55841088"/>
        <c:crosses val="autoZero"/>
        <c:auto val="1"/>
        <c:lblAlgn val="ctr"/>
        <c:lblOffset val="100"/>
        <c:noMultiLvlLbl val="0"/>
      </c:catAx>
      <c:valAx>
        <c:axId val="95584108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5829120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NTES</a:t>
            </a:r>
            <a:endParaRPr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2760750844714182"/>
          <c:y val="8.8302860734568549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DA1B-4BD3-90F9-CDD08B2BFD3E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DA1B-4BD3-90F9-CDD08B2BFD3E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DA1B-4BD3-90F9-CDD08B2BFD3E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DA1B-4BD3-90F9-CDD08B2BFD3E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51:$J$54</c:f>
                <c:numCache>
                  <c:formatCode>General</c:formatCode>
                  <c:ptCount val="4"/>
                  <c:pt idx="0">
                    <c:v>0.16012815380508683</c:v>
                  </c:pt>
                  <c:pt idx="1">
                    <c:v>4.05966580232817</c:v>
                  </c:pt>
                  <c:pt idx="2">
                    <c:v>3.058297826498892</c:v>
                  </c:pt>
                  <c:pt idx="3">
                    <c:v>2.887970561002809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44:$H$47</c:f>
              <c:strCache>
                <c:ptCount val="4"/>
                <c:pt idx="0">
                  <c:v>control</c:v>
                </c:pt>
                <c:pt idx="1">
                  <c:v>HDM-PBS-placebo</c:v>
                </c:pt>
                <c:pt idx="2">
                  <c:v>HDM-PBS-CAM</c:v>
                </c:pt>
                <c:pt idx="3">
                  <c:v>HDM-PBS-EM900</c:v>
                </c:pt>
              </c:strCache>
            </c:strRef>
          </c:cat>
          <c:val>
            <c:numRef>
              <c:f>Sheet1!$J$44:$J$47</c:f>
              <c:numCache>
                <c:formatCode>0.0_ </c:formatCode>
                <c:ptCount val="4"/>
                <c:pt idx="0" formatCode="0.0">
                  <c:v>6.666666666666667</c:v>
                </c:pt>
                <c:pt idx="1">
                  <c:v>20.157894736842103</c:v>
                </c:pt>
                <c:pt idx="2">
                  <c:v>18.578947368421055</c:v>
                </c:pt>
                <c:pt idx="3">
                  <c:v>17.85526315789473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DA1B-4BD3-90F9-CDD08B2BFD3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55831840"/>
        <c:axId val="955827488"/>
      </c:barChart>
      <c:catAx>
        <c:axId val="95583184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55827488"/>
        <c:crosses val="autoZero"/>
        <c:auto val="1"/>
        <c:lblAlgn val="ctr"/>
        <c:lblOffset val="100"/>
        <c:noMultiLvlLbl val="0"/>
      </c:catAx>
      <c:valAx>
        <c:axId val="95582748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58318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-5</a:t>
            </a:r>
            <a:endParaRPr lang="ja-JP" alt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42891118369129955"/>
          <c:y val="8.8260639924387738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FBE6-474B-9128-DDFD7350FB82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FBE6-474B-9128-DDFD7350FB82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FBE6-474B-9128-DDFD7350FB82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FBE6-474B-9128-DDFD7350FB82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51:$J$54</c:f>
                <c:numCache>
                  <c:formatCode>General</c:formatCode>
                  <c:ptCount val="4"/>
                  <c:pt idx="0">
                    <c:v>0.18803281441647651</c:v>
                  </c:pt>
                  <c:pt idx="1">
                    <c:v>1.9777675864090627</c:v>
                  </c:pt>
                  <c:pt idx="2">
                    <c:v>11.073540505173952</c:v>
                  </c:pt>
                  <c:pt idx="3">
                    <c:v>4.401704215414793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44:$H$47</c:f>
              <c:strCache>
                <c:ptCount val="4"/>
                <c:pt idx="0">
                  <c:v>control</c:v>
                </c:pt>
                <c:pt idx="1">
                  <c:v>HDM-PBS-placebo</c:v>
                </c:pt>
                <c:pt idx="2">
                  <c:v>HDM-PBS-CAM</c:v>
                </c:pt>
                <c:pt idx="3">
                  <c:v>HDM-PBS-EM900</c:v>
                </c:pt>
              </c:strCache>
            </c:strRef>
          </c:cat>
          <c:val>
            <c:numRef>
              <c:f>Sheet1!$J$44:$J$47</c:f>
              <c:numCache>
                <c:formatCode>0.0_ </c:formatCode>
                <c:ptCount val="4"/>
                <c:pt idx="0" formatCode="0.0">
                  <c:v>21.626657196390301</c:v>
                </c:pt>
                <c:pt idx="1">
                  <c:v>39.404761904761905</c:v>
                </c:pt>
                <c:pt idx="2">
                  <c:v>37.202380952380956</c:v>
                </c:pt>
                <c:pt idx="3">
                  <c:v>29.46428571428571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FBE6-474B-9128-DDFD7350FB8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55830208"/>
        <c:axId val="955839456"/>
      </c:barChart>
      <c:catAx>
        <c:axId val="9558302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55839456"/>
        <c:crosses val="autoZero"/>
        <c:auto val="1"/>
        <c:lblAlgn val="ctr"/>
        <c:lblOffset val="100"/>
        <c:noMultiLvlLbl val="0"/>
      </c:catAx>
      <c:valAx>
        <c:axId val="955839456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5830208"/>
        <c:crosses val="autoZero"/>
        <c:crossBetween val="between"/>
        <c:majorUnit val="1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-13</a:t>
            </a:r>
            <a:endParaRPr lang="ja-JP" alt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9362798015140055"/>
          <c:y val="9.030263470380025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070B-43D7-9E34-8E0958D4FB5E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070B-43D7-9E34-8E0958D4FB5E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070B-43D7-9E34-8E0958D4FB5E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6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070B-43D7-9E34-8E0958D4FB5E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51:$J$54</c:f>
                <c:numCache>
                  <c:formatCode>General</c:formatCode>
                  <c:ptCount val="4"/>
                  <c:pt idx="0">
                    <c:v>4.3643578047198295</c:v>
                  </c:pt>
                  <c:pt idx="1">
                    <c:v>108.99067238377168</c:v>
                  </c:pt>
                  <c:pt idx="2">
                    <c:v>87.588621787688126</c:v>
                  </c:pt>
                  <c:pt idx="3">
                    <c:v>36.6114736114240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44:$H$47</c:f>
              <c:strCache>
                <c:ptCount val="4"/>
                <c:pt idx="0">
                  <c:v>control</c:v>
                </c:pt>
                <c:pt idx="1">
                  <c:v>HDM-placebo</c:v>
                </c:pt>
                <c:pt idx="2">
                  <c:v>HDM-CAM</c:v>
                </c:pt>
                <c:pt idx="3">
                  <c:v>HDM-EM900</c:v>
                </c:pt>
              </c:strCache>
            </c:strRef>
          </c:cat>
          <c:val>
            <c:numRef>
              <c:f>Sheet1!$J$44:$J$47</c:f>
              <c:numCache>
                <c:formatCode>0.0_ </c:formatCode>
                <c:ptCount val="4"/>
                <c:pt idx="0" formatCode="0.0">
                  <c:v>203.80952380952382</c:v>
                </c:pt>
                <c:pt idx="1">
                  <c:v>421.83333333333331</c:v>
                </c:pt>
                <c:pt idx="2">
                  <c:v>379.83333333333331</c:v>
                </c:pt>
                <c:pt idx="3">
                  <c:v>3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070B-43D7-9E34-8E0958D4FB5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55826944"/>
        <c:axId val="955828032"/>
      </c:barChart>
      <c:catAx>
        <c:axId val="95582694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55828032"/>
        <c:crosses val="autoZero"/>
        <c:auto val="1"/>
        <c:lblAlgn val="ctr"/>
        <c:lblOffset val="100"/>
        <c:noMultiLvlLbl val="0"/>
      </c:catAx>
      <c:valAx>
        <c:axId val="955828032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5826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3914764891676675E-2"/>
          <c:y val="5.1400554097404488E-2"/>
          <c:w val="0.89785221762533918"/>
          <c:h val="0.82893919510061242"/>
        </c:manualLayout>
      </c:layout>
      <c:barChart>
        <c:barDir val="col"/>
        <c:grouping val="clustered"/>
        <c:varyColors val="0"/>
        <c:ser>
          <c:idx val="3"/>
          <c:order val="0"/>
          <c:tx>
            <c:strRef>
              <c:f>Sheet2!$B$5</c:f>
              <c:strCache>
                <c:ptCount val="1"/>
                <c:pt idx="0">
                  <c:v>PBS-PBS-PB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C$6:$G$6</c:f>
                <c:numCache>
                  <c:formatCode>General</c:formatCode>
                  <c:ptCount val="5"/>
                  <c:pt idx="0">
                    <c:v>0.40808495847474358</c:v>
                  </c:pt>
                  <c:pt idx="1">
                    <c:v>0.23115147566044233</c:v>
                  </c:pt>
                  <c:pt idx="2">
                    <c:v>1.0400001602563984E-2</c:v>
                  </c:pt>
                  <c:pt idx="3">
                    <c:v>3.850069263446225E-2</c:v>
                  </c:pt>
                  <c:pt idx="4">
                    <c:v>0.4468238147562564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2!$C$5:$G$5</c:f>
              <c:numCache>
                <c:formatCode>0.00</c:formatCode>
                <c:ptCount val="5"/>
                <c:pt idx="0">
                  <c:v>4.6766666666666667</c:v>
                </c:pt>
                <c:pt idx="1">
                  <c:v>0.57755999999999996</c:v>
                </c:pt>
                <c:pt idx="2">
                  <c:v>8.8763333333333347E-2</c:v>
                </c:pt>
                <c:pt idx="3">
                  <c:v>9.0866666666666665E-2</c:v>
                </c:pt>
                <c:pt idx="4">
                  <c:v>3.9194766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863-4704-ACCA-FC95A3438463}"/>
            </c:ext>
          </c:extLst>
        </c:ser>
        <c:ser>
          <c:idx val="0"/>
          <c:order val="1"/>
          <c:tx>
            <c:strRef>
              <c:f>Sheet2!$B$7</c:f>
              <c:strCache>
                <c:ptCount val="1"/>
                <c:pt idx="0">
                  <c:v>HDM-PBS-placebo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C$8:$G$8</c:f>
                <c:numCache>
                  <c:formatCode>General</c:formatCode>
                  <c:ptCount val="5"/>
                  <c:pt idx="0">
                    <c:v>8.4547422590323098</c:v>
                  </c:pt>
                  <c:pt idx="1">
                    <c:v>0.51148661924498728</c:v>
                  </c:pt>
                  <c:pt idx="2">
                    <c:v>0.49115094489033273</c:v>
                  </c:pt>
                  <c:pt idx="3">
                    <c:v>8.1342443730195466</c:v>
                  </c:pt>
                  <c:pt idx="4">
                    <c:v>1.451694694830825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2!$C$4:$G$4</c:f>
              <c:strCache>
                <c:ptCount val="5"/>
                <c:pt idx="0">
                  <c:v>total cells</c:v>
                </c:pt>
                <c:pt idx="1">
                  <c:v>neutrophils</c:v>
                </c:pt>
                <c:pt idx="2">
                  <c:v>lymphocytes</c:v>
                </c:pt>
                <c:pt idx="3">
                  <c:v>eosiniphils</c:v>
                </c:pt>
                <c:pt idx="4">
                  <c:v>macrophages</c:v>
                </c:pt>
              </c:strCache>
            </c:strRef>
          </c:cat>
          <c:val>
            <c:numRef>
              <c:f>Sheet2!$C$7:$G$7</c:f>
              <c:numCache>
                <c:formatCode>0.00_ </c:formatCode>
                <c:ptCount val="5"/>
                <c:pt idx="0">
                  <c:v>33.533333333333331</c:v>
                </c:pt>
                <c:pt idx="1">
                  <c:v>1.4365166666666667</c:v>
                </c:pt>
                <c:pt idx="2">
                  <c:v>1.1921666666666666</c:v>
                </c:pt>
                <c:pt idx="3">
                  <c:v>23.092100000000002</c:v>
                </c:pt>
                <c:pt idx="4">
                  <c:v>7.81255000000000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863-4704-ACCA-FC95A3438463}"/>
            </c:ext>
          </c:extLst>
        </c:ser>
        <c:ser>
          <c:idx val="2"/>
          <c:order val="2"/>
          <c:tx>
            <c:strRef>
              <c:f>Sheet2!$B$9</c:f>
              <c:strCache>
                <c:ptCount val="1"/>
                <c:pt idx="0">
                  <c:v>HDM-PBS-CAM</c:v>
                </c:pt>
              </c:strCache>
            </c:strRef>
          </c:tx>
          <c:spPr>
            <a:pattFill prst="lt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  <a:prstDash val="solid"/>
            </a:ln>
          </c:spPr>
          <c:invertIfNegative val="0"/>
          <c:dPt>
            <c:idx val="0"/>
            <c:invertIfNegative val="0"/>
            <c:bubble3D val="0"/>
            <c:extLst xmlns:c16r2="http://schemas.microsoft.com/office/drawing/2015/06/chart">
              <c:ext xmlns:c16="http://schemas.microsoft.com/office/drawing/2014/chart" uri="{C3380CC4-5D6E-409C-BE32-E72D297353CC}">
                <c16:uniqueId val="{00000002-9863-4704-ACCA-FC95A3438463}"/>
              </c:ext>
            </c:extLst>
          </c:dPt>
          <c:errBars>
            <c:errBarType val="plus"/>
            <c:errValType val="cust"/>
            <c:noEndCap val="0"/>
            <c:plus>
              <c:numRef>
                <c:f>Sheet2!$C$10:$G$10</c:f>
                <c:numCache>
                  <c:formatCode>General</c:formatCode>
                  <c:ptCount val="5"/>
                  <c:pt idx="0">
                    <c:v>9.4529184206078067</c:v>
                  </c:pt>
                  <c:pt idx="1">
                    <c:v>0.51143237187334978</c:v>
                  </c:pt>
                  <c:pt idx="2">
                    <c:v>0.47129005258616091</c:v>
                  </c:pt>
                  <c:pt idx="3">
                    <c:v>8.0893009877862774</c:v>
                  </c:pt>
                  <c:pt idx="4">
                    <c:v>2.60565600473278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Sheet2!$C$4:$G$4</c:f>
              <c:strCache>
                <c:ptCount val="5"/>
                <c:pt idx="0">
                  <c:v>total cells</c:v>
                </c:pt>
                <c:pt idx="1">
                  <c:v>neutrophils</c:v>
                </c:pt>
                <c:pt idx="2">
                  <c:v>lymphocytes</c:v>
                </c:pt>
                <c:pt idx="3">
                  <c:v>eosiniphils</c:v>
                </c:pt>
                <c:pt idx="4">
                  <c:v>macrophages</c:v>
                </c:pt>
              </c:strCache>
            </c:strRef>
          </c:cat>
          <c:val>
            <c:numRef>
              <c:f>Sheet2!$C$9:$G$9</c:f>
              <c:numCache>
                <c:formatCode>0.00_ </c:formatCode>
                <c:ptCount val="5"/>
                <c:pt idx="0">
                  <c:v>26.783333333333335</c:v>
                </c:pt>
                <c:pt idx="1">
                  <c:v>0.80765000000000009</c:v>
                </c:pt>
                <c:pt idx="2">
                  <c:v>0.99388333333333356</c:v>
                </c:pt>
                <c:pt idx="3">
                  <c:v>18.699249999999996</c:v>
                </c:pt>
                <c:pt idx="4">
                  <c:v>6.282550000000000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9863-4704-ACCA-FC95A3438463}"/>
            </c:ext>
          </c:extLst>
        </c:ser>
        <c:ser>
          <c:idx val="1"/>
          <c:order val="3"/>
          <c:tx>
            <c:strRef>
              <c:f>Sheet2!$B$11</c:f>
              <c:strCache>
                <c:ptCount val="1"/>
                <c:pt idx="0">
                  <c:v>HDM-PBS-EM900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2!$C$12:$G$12</c:f>
                <c:numCache>
                  <c:formatCode>General</c:formatCode>
                  <c:ptCount val="5"/>
                  <c:pt idx="0">
                    <c:v>6.1266630395346429</c:v>
                  </c:pt>
                  <c:pt idx="1">
                    <c:v>0.65452197518494359</c:v>
                  </c:pt>
                  <c:pt idx="2">
                    <c:v>0.656982629907367</c:v>
                  </c:pt>
                  <c:pt idx="3">
                    <c:v>5.1323409690575579</c:v>
                  </c:pt>
                  <c:pt idx="4">
                    <c:v>1.194954683101686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2!$C$11:$G$11</c:f>
              <c:numCache>
                <c:formatCode>0.00_ </c:formatCode>
                <c:ptCount val="5"/>
                <c:pt idx="0">
                  <c:v>27.099999999999998</c:v>
                </c:pt>
                <c:pt idx="1">
                  <c:v>1.0317000000000001</c:v>
                </c:pt>
                <c:pt idx="2">
                  <c:v>1.3023</c:v>
                </c:pt>
                <c:pt idx="3">
                  <c:v>18.369933333333332</c:v>
                </c:pt>
                <c:pt idx="4">
                  <c:v>6.39606666666666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9863-4704-ACCA-FC95A34384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5833472"/>
        <c:axId val="956568800"/>
      </c:barChart>
      <c:catAx>
        <c:axId val="95583347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lang="ja-JP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956568800"/>
        <c:crosses val="autoZero"/>
        <c:auto val="1"/>
        <c:lblAlgn val="ctr"/>
        <c:lblOffset val="100"/>
        <c:noMultiLvlLbl val="0"/>
      </c:catAx>
      <c:valAx>
        <c:axId val="956568800"/>
        <c:scaling>
          <c:orientation val="minMax"/>
        </c:scaling>
        <c:delete val="0"/>
        <c:axPos val="l"/>
        <c:numFmt formatCode="0_ " sourceLinked="0"/>
        <c:majorTickMark val="out"/>
        <c:minorTickMark val="none"/>
        <c:tickLblPos val="nextTo"/>
        <c:txPr>
          <a:bodyPr/>
          <a:lstStyle/>
          <a:p>
            <a:pPr>
              <a:defRPr lang="ja-JP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955833472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IP-2</a:t>
            </a:r>
            <a:endParaRPr lang="ja-JP" alt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9100854267059831"/>
          <c:y val="1.74639702479952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5F8B-41DE-B67F-7BE2E0DA037C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5F8B-41DE-B67F-7BE2E0DA037C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5F8B-41DE-B67F-7BE2E0DA037C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51:$J$53</c:f>
                <c:numCache>
                  <c:formatCode>General</c:formatCode>
                  <c:ptCount val="3"/>
                  <c:pt idx="0">
                    <c:v>0.31208122658898674</c:v>
                  </c:pt>
                  <c:pt idx="1">
                    <c:v>4.9168889980393811</c:v>
                  </c:pt>
                  <c:pt idx="2">
                    <c:v>25.6958668830644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44:$H$46</c:f>
              <c:strCache>
                <c:ptCount val="3"/>
                <c:pt idx="0">
                  <c:v>control</c:v>
                </c:pt>
                <c:pt idx="1">
                  <c:v>HDM-PBS</c:v>
                </c:pt>
                <c:pt idx="2">
                  <c:v>HDM-Poly(I:C)</c:v>
                </c:pt>
              </c:strCache>
            </c:strRef>
          </c:cat>
          <c:val>
            <c:numRef>
              <c:f>Sheet1!$I$44:$I$46</c:f>
              <c:numCache>
                <c:formatCode>0.0_ </c:formatCode>
                <c:ptCount val="3"/>
                <c:pt idx="0" formatCode="0.0">
                  <c:v>43.693693693693696</c:v>
                </c:pt>
                <c:pt idx="1">
                  <c:v>76.261261261261254</c:v>
                </c:pt>
                <c:pt idx="2">
                  <c:v>101.891891891891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5F8B-41DE-B67F-7BE2E0DA037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56579680"/>
        <c:axId val="956580768"/>
      </c:barChart>
      <c:catAx>
        <c:axId val="956579680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56580768"/>
        <c:crosses val="autoZero"/>
        <c:auto val="1"/>
        <c:lblAlgn val="ctr"/>
        <c:lblOffset val="100"/>
        <c:noMultiLvlLbl val="0"/>
      </c:catAx>
      <c:valAx>
        <c:axId val="956580768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65796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L-17A</a:t>
            </a:r>
            <a:endParaRPr lang="ja-JP" alt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8960614569245455"/>
          <c:y val="8.7328497489133784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3F43-4B5B-A121-3E74D6349636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3F43-4B5B-A121-3E74D6349636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3F43-4B5B-A121-3E74D6349636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51:$J$53</c:f>
                <c:numCache>
                  <c:formatCode>General</c:formatCode>
                  <c:ptCount val="3"/>
                  <c:pt idx="0">
                    <c:v>3.5529247334746241</c:v>
                  </c:pt>
                  <c:pt idx="1">
                    <c:v>40.941739509891129</c:v>
                  </c:pt>
                  <c:pt idx="2">
                    <c:v>34.93374541040704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44:$H$46</c:f>
              <c:strCache>
                <c:ptCount val="3"/>
                <c:pt idx="0">
                  <c:v>control</c:v>
                </c:pt>
                <c:pt idx="1">
                  <c:v>HDM-PBS</c:v>
                </c:pt>
                <c:pt idx="2">
                  <c:v>HDM-Poly(I:C)</c:v>
                </c:pt>
              </c:strCache>
            </c:strRef>
          </c:cat>
          <c:val>
            <c:numRef>
              <c:f>Sheet1!$J$44:$J$46</c:f>
              <c:numCache>
                <c:formatCode>0.0_ </c:formatCode>
                <c:ptCount val="3"/>
                <c:pt idx="0" formatCode="0.0">
                  <c:v>38.717948717948723</c:v>
                </c:pt>
                <c:pt idx="1">
                  <c:v>158.55702917771887</c:v>
                </c:pt>
                <c:pt idx="2">
                  <c:v>209.029177718832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3F43-4B5B-A121-3E74D63496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56582944"/>
        <c:axId val="956580224"/>
      </c:barChart>
      <c:catAx>
        <c:axId val="956582944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56580224"/>
        <c:crosses val="autoZero"/>
        <c:auto val="1"/>
        <c:lblAlgn val="ctr"/>
        <c:lblOffset val="100"/>
        <c:noMultiLvlLbl val="0"/>
      </c:catAx>
      <c:valAx>
        <c:axId val="95658022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65829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1200" b="0" i="0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altLang="ja-JP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ANTES</a:t>
            </a:r>
            <a:endParaRPr lang="ja-JP" altLang="en-US" sz="120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32760750844714182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200" b="0" i="0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24C-45B5-8CF0-B3C24B1E95C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24C-45B5-8CF0-B3C24B1E95C7}"/>
              </c:ext>
            </c:extLst>
          </c:dPt>
          <c:dPt>
            <c:idx val="2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424C-45B5-8CF0-B3C24B1E95C7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51:$J$54</c:f>
                <c:numCache>
                  <c:formatCode>General</c:formatCode>
                  <c:ptCount val="4"/>
                  <c:pt idx="0">
                    <c:v>0.16012815380508683</c:v>
                  </c:pt>
                  <c:pt idx="1">
                    <c:v>3.7705387578772585</c:v>
                  </c:pt>
                  <c:pt idx="2">
                    <c:v>7.5842278987720935</c:v>
                  </c:pt>
                  <c:pt idx="3">
                    <c:v>4.131468689288562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H$44:$H$46</c:f>
              <c:strCache>
                <c:ptCount val="3"/>
                <c:pt idx="0">
                  <c:v>control</c:v>
                </c:pt>
                <c:pt idx="1">
                  <c:v>HDM-PBS-placebo</c:v>
                </c:pt>
                <c:pt idx="2">
                  <c:v>HDM-Poly(I:C)-placebo</c:v>
                </c:pt>
              </c:strCache>
            </c:strRef>
          </c:cat>
          <c:val>
            <c:numRef>
              <c:f>Sheet1!$J$44:$J$46</c:f>
              <c:numCache>
                <c:formatCode>0.0_ </c:formatCode>
                <c:ptCount val="3"/>
                <c:pt idx="0" formatCode="0.0">
                  <c:v>6.666666666666667</c:v>
                </c:pt>
                <c:pt idx="1">
                  <c:v>24.871794871794876</c:v>
                </c:pt>
                <c:pt idx="2">
                  <c:v>31.91025641025640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424C-45B5-8CF0-B3C24B1E95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956581856"/>
        <c:axId val="956574784"/>
      </c:barChart>
      <c:catAx>
        <c:axId val="95658185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956574784"/>
        <c:crosses val="autoZero"/>
        <c:auto val="1"/>
        <c:lblAlgn val="ctr"/>
        <c:lblOffset val="100"/>
        <c:noMultiLvlLbl val="0"/>
      </c:catAx>
      <c:valAx>
        <c:axId val="95657478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65818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19F4D-B37A-4E35-A789-DA7884DCDD36}" type="datetimeFigureOut">
              <a:rPr kumimoji="1" lang="ja-JP" altLang="en-US" smtClean="0"/>
              <a:t>2019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E8E9E-FB7A-4863-9A7B-7EDFAAB0D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7858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19F4D-B37A-4E35-A789-DA7884DCDD36}" type="datetimeFigureOut">
              <a:rPr kumimoji="1" lang="ja-JP" altLang="en-US" smtClean="0"/>
              <a:t>2019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E8E9E-FB7A-4863-9A7B-7EDFAAB0D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5490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19F4D-B37A-4E35-A789-DA7884DCDD36}" type="datetimeFigureOut">
              <a:rPr kumimoji="1" lang="ja-JP" altLang="en-US" smtClean="0"/>
              <a:t>2019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E8E9E-FB7A-4863-9A7B-7EDFAAB0D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2252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19F4D-B37A-4E35-A789-DA7884DCDD36}" type="datetimeFigureOut">
              <a:rPr kumimoji="1" lang="ja-JP" altLang="en-US" smtClean="0"/>
              <a:t>2019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E8E9E-FB7A-4863-9A7B-7EDFAAB0D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7992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19F4D-B37A-4E35-A789-DA7884DCDD36}" type="datetimeFigureOut">
              <a:rPr kumimoji="1" lang="ja-JP" altLang="en-US" smtClean="0"/>
              <a:t>2019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E8E9E-FB7A-4863-9A7B-7EDFAAB0D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79504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19F4D-B37A-4E35-A789-DA7884DCDD36}" type="datetimeFigureOut">
              <a:rPr kumimoji="1" lang="ja-JP" altLang="en-US" smtClean="0"/>
              <a:t>2019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E8E9E-FB7A-4863-9A7B-7EDFAAB0D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3218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19F4D-B37A-4E35-A789-DA7884DCDD36}" type="datetimeFigureOut">
              <a:rPr kumimoji="1" lang="ja-JP" altLang="en-US" smtClean="0"/>
              <a:t>2019/12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E8E9E-FB7A-4863-9A7B-7EDFAAB0D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7289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19F4D-B37A-4E35-A789-DA7884DCDD36}" type="datetimeFigureOut">
              <a:rPr kumimoji="1" lang="ja-JP" altLang="en-US" smtClean="0"/>
              <a:t>2019/12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E8E9E-FB7A-4863-9A7B-7EDFAAB0D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4065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19F4D-B37A-4E35-A789-DA7884DCDD36}" type="datetimeFigureOut">
              <a:rPr kumimoji="1" lang="ja-JP" altLang="en-US" smtClean="0"/>
              <a:t>2019/12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E8E9E-FB7A-4863-9A7B-7EDFAAB0D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1885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19F4D-B37A-4E35-A789-DA7884DCDD36}" type="datetimeFigureOut">
              <a:rPr kumimoji="1" lang="ja-JP" altLang="en-US" smtClean="0"/>
              <a:t>2019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E8E9E-FB7A-4863-9A7B-7EDFAAB0D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3090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119F4D-B37A-4E35-A789-DA7884DCDD36}" type="datetimeFigureOut">
              <a:rPr kumimoji="1" lang="ja-JP" altLang="en-US" smtClean="0"/>
              <a:t>2019/12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9E8E9E-FB7A-4863-9A7B-7EDFAAB0D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3233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119F4D-B37A-4E35-A789-DA7884DCDD36}" type="datetimeFigureOut">
              <a:rPr kumimoji="1" lang="ja-JP" altLang="en-US" smtClean="0"/>
              <a:t>2019/12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9E8E9E-FB7A-4863-9A7B-7EDFAAB0DD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166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openxmlformats.org/officeDocument/2006/relationships/chart" Target="../charts/chart8.xml"/><Relationship Id="rId7" Type="http://schemas.openxmlformats.org/officeDocument/2006/relationships/chart" Target="../charts/chart12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1.xml"/><Relationship Id="rId5" Type="http://schemas.openxmlformats.org/officeDocument/2006/relationships/chart" Target="../charts/chart10.xml"/><Relationship Id="rId4" Type="http://schemas.openxmlformats.org/officeDocument/2006/relationships/chart" Target="../charts/chart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7" name="グラフ 136">
            <a:extLst>
              <a:ext uri="{FF2B5EF4-FFF2-40B4-BE49-F238E27FC236}">
                <a16:creationId xmlns:a16="http://schemas.microsoft.com/office/drawing/2014/main" xmlns="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9807553"/>
              </p:ext>
            </p:extLst>
          </p:nvPr>
        </p:nvGraphicFramePr>
        <p:xfrm>
          <a:off x="2435125" y="5081010"/>
          <a:ext cx="2175198" cy="14479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6" name="グラフ 135">
            <a:extLst>
              <a:ext uri="{FF2B5EF4-FFF2-40B4-BE49-F238E27FC236}">
                <a16:creationId xmlns:a16="http://schemas.microsoft.com/office/drawing/2014/main" xmlns="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0119066"/>
              </p:ext>
            </p:extLst>
          </p:nvPr>
        </p:nvGraphicFramePr>
        <p:xfrm>
          <a:off x="81189" y="5081456"/>
          <a:ext cx="2190756" cy="14479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5" name="グラフ 134">
            <a:extLst>
              <a:ext uri="{FF2B5EF4-FFF2-40B4-BE49-F238E27FC236}">
                <a16:creationId xmlns:a16="http://schemas.microsoft.com/office/drawing/2014/main" xmlns="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40249570"/>
              </p:ext>
            </p:extLst>
          </p:nvPr>
        </p:nvGraphicFramePr>
        <p:xfrm>
          <a:off x="4523994" y="3090299"/>
          <a:ext cx="2161086" cy="1438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4" name="グラフ 133">
            <a:extLst>
              <a:ext uri="{FF2B5EF4-FFF2-40B4-BE49-F238E27FC236}">
                <a16:creationId xmlns:a16="http://schemas.microsoft.com/office/drawing/2014/main" xmlns="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70171698"/>
              </p:ext>
            </p:extLst>
          </p:nvPr>
        </p:nvGraphicFramePr>
        <p:xfrm>
          <a:off x="2256509" y="3081847"/>
          <a:ext cx="2261713" cy="14389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3" name="グラフ 132">
            <a:extLst>
              <a:ext uri="{FF2B5EF4-FFF2-40B4-BE49-F238E27FC236}">
                <a16:creationId xmlns:a16="http://schemas.microsoft.com/office/drawing/2014/main" xmlns="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3715126"/>
              </p:ext>
            </p:extLst>
          </p:nvPr>
        </p:nvGraphicFramePr>
        <p:xfrm>
          <a:off x="100648" y="3101665"/>
          <a:ext cx="2227865" cy="140638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48" name="グラフ 47">
            <a:extLst>
              <a:ext uri="{FF2B5EF4-FFF2-40B4-BE49-F238E27FC236}">
                <a16:creationId xmlns:a16="http://schemas.microsoft.com/office/drawing/2014/main" xmlns="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2350314"/>
              </p:ext>
            </p:extLst>
          </p:nvPr>
        </p:nvGraphicFramePr>
        <p:xfrm>
          <a:off x="757894" y="596868"/>
          <a:ext cx="4938317" cy="19972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7A9A3BE7-6845-4E9E-97C7-63FD6C46BF46}"/>
              </a:ext>
            </a:extLst>
          </p:cNvPr>
          <p:cNvSpPr txBox="1"/>
          <p:nvPr/>
        </p:nvSpPr>
        <p:spPr>
          <a:xfrm>
            <a:off x="49422" y="12355"/>
            <a:ext cx="16417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D0F39807-BCEB-4736-93E6-3D7D23718DE1}"/>
              </a:ext>
            </a:extLst>
          </p:cNvPr>
          <p:cNvSpPr txBox="1"/>
          <p:nvPr/>
        </p:nvSpPr>
        <p:spPr>
          <a:xfrm>
            <a:off x="201822" y="404243"/>
            <a:ext cx="3225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 useBgFill="1">
        <p:nvSpPr>
          <p:cNvPr id="8" name="テキスト ボックス 199">
            <a:extLst>
              <a:ext uri="{FF2B5EF4-FFF2-40B4-BE49-F238E27FC236}">
                <a16:creationId xmlns:a16="http://schemas.microsoft.com/office/drawing/2014/main" xmlns="" id="{1EE5350D-88C5-45DD-AC57-F168709AFF3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40048" y="1381858"/>
            <a:ext cx="1595885" cy="246221"/>
          </a:xfrm>
          <a:prstGeom prst="rect">
            <a:avLst/>
          </a:prstGeom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97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85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73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ea typeface="ＭＳ Ｐゴシック" panose="020B0600070205080204" pitchFamily="50" charset="-128"/>
                <a:cs typeface="Times New Roman" panose="02020603050405020304" pitchFamily="18" charset="0"/>
              </a:rPr>
              <a:t>Cell number (x 10</a:t>
            </a:r>
            <a:r>
              <a:rPr lang="en-US" altLang="ja-JP" sz="1000" baseline="30000" dirty="0">
                <a:ea typeface="ＭＳ Ｐゴシック" panose="020B0600070205080204" pitchFamily="50" charset="-128"/>
                <a:cs typeface="Times New Roman" panose="02020603050405020304" pitchFamily="18" charset="0"/>
              </a:rPr>
              <a:t>4 </a:t>
            </a:r>
            <a:r>
              <a:rPr lang="en-US" altLang="ja-JP" sz="1000" dirty="0">
                <a:ea typeface="ＭＳ Ｐゴシック" panose="020B0600070205080204" pitchFamily="50" charset="-128"/>
                <a:cs typeface="Times New Roman" panose="02020603050405020304" pitchFamily="18" charset="0"/>
              </a:rPr>
              <a:t>/ ml)</a:t>
            </a:r>
            <a:endParaRPr lang="ja-JP" altLang="en-US" sz="1000" dirty="0"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xmlns="" id="{64411178-0C82-4113-BEF6-167F8C16D071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609126" y="723379"/>
            <a:ext cx="156060" cy="597405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145D37B9-8A5C-49A8-A1ED-B7A61F462572}"/>
              </a:ext>
            </a:extLst>
          </p:cNvPr>
          <p:cNvSpPr txBox="1"/>
          <p:nvPr/>
        </p:nvSpPr>
        <p:spPr>
          <a:xfrm>
            <a:off x="2686825" y="671520"/>
            <a:ext cx="928459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M-placebo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M-CAM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M-EM900</a:t>
            </a:r>
          </a:p>
        </p:txBody>
      </p:sp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xmlns="" id="{F17EDB59-F450-4B4C-9EF2-398DD9F09BF6}"/>
              </a:ext>
            </a:extLst>
          </p:cNvPr>
          <p:cNvGrpSpPr/>
          <p:nvPr/>
        </p:nvGrpSpPr>
        <p:grpSpPr>
          <a:xfrm>
            <a:off x="5016798" y="1461497"/>
            <a:ext cx="583472" cy="476205"/>
            <a:chOff x="5564385" y="1233375"/>
            <a:chExt cx="583472" cy="476205"/>
          </a:xfrm>
        </p:grpSpPr>
        <p:sp>
          <p:nvSpPr>
            <p:cNvPr id="41" name="テキスト ボックス 214">
              <a:extLst>
                <a:ext uri="{FF2B5EF4-FFF2-40B4-BE49-F238E27FC236}">
                  <a16:creationId xmlns:a16="http://schemas.microsoft.com/office/drawing/2014/main" xmlns="" id="{4B305276-0E35-4DC7-BEE6-860C5BE0E38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241" y="1472468"/>
              <a:ext cx="34761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2" name="フリーフォーム 107">
              <a:extLst>
                <a:ext uri="{FF2B5EF4-FFF2-40B4-BE49-F238E27FC236}">
                  <a16:creationId xmlns:a16="http://schemas.microsoft.com/office/drawing/2014/main" xmlns="" id="{68987B52-4952-4161-81CB-C5705C5E65DD}"/>
                </a:ext>
              </a:extLst>
            </p:cNvPr>
            <p:cNvSpPr/>
            <p:nvPr/>
          </p:nvSpPr>
          <p:spPr>
            <a:xfrm>
              <a:off x="5833051" y="1654315"/>
              <a:ext cx="223540" cy="53382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3" name="テキスト ボックス 214">
              <a:extLst>
                <a:ext uri="{FF2B5EF4-FFF2-40B4-BE49-F238E27FC236}">
                  <a16:creationId xmlns:a16="http://schemas.microsoft.com/office/drawing/2014/main" xmlns="" id="{974E0A34-049C-46D3-AE1F-3554463EB66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64385" y="1472468"/>
              <a:ext cx="3199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4" name="フリーフォーム 92">
              <a:extLst>
                <a:ext uri="{FF2B5EF4-FFF2-40B4-BE49-F238E27FC236}">
                  <a16:creationId xmlns:a16="http://schemas.microsoft.com/office/drawing/2014/main" xmlns="" id="{26D86494-36F9-4F28-AEDB-2DCF529A7C7C}"/>
                </a:ext>
              </a:extLst>
            </p:cNvPr>
            <p:cNvSpPr/>
            <p:nvPr/>
          </p:nvSpPr>
          <p:spPr>
            <a:xfrm>
              <a:off x="5618054" y="1653455"/>
              <a:ext cx="187938" cy="56125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5" name="フリーフォーム 93">
              <a:extLst>
                <a:ext uri="{FF2B5EF4-FFF2-40B4-BE49-F238E27FC236}">
                  <a16:creationId xmlns:a16="http://schemas.microsoft.com/office/drawing/2014/main" xmlns="" id="{5A425EDF-6FE3-437B-A901-C899948D9636}"/>
                </a:ext>
              </a:extLst>
            </p:cNvPr>
            <p:cNvSpPr/>
            <p:nvPr/>
          </p:nvSpPr>
          <p:spPr>
            <a:xfrm>
              <a:off x="5614185" y="1419604"/>
              <a:ext cx="437733" cy="70641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46" name="テキスト ボックス 214">
              <a:extLst>
                <a:ext uri="{FF2B5EF4-FFF2-40B4-BE49-F238E27FC236}">
                  <a16:creationId xmlns:a16="http://schemas.microsoft.com/office/drawing/2014/main" xmlns="" id="{1F736BD5-3B85-43F2-B779-2943E4873A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80024" y="1233375"/>
              <a:ext cx="42008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01AD1A6B-DD15-4379-9724-91BBD0D45BC6}"/>
              </a:ext>
            </a:extLst>
          </p:cNvPr>
          <p:cNvSpPr txBox="1"/>
          <p:nvPr/>
        </p:nvSpPr>
        <p:spPr>
          <a:xfrm>
            <a:off x="5292822" y="12355"/>
            <a:ext cx="13035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damatsu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 et al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9" name="グループ化 48">
            <a:extLst>
              <a:ext uri="{FF2B5EF4-FFF2-40B4-BE49-F238E27FC236}">
                <a16:creationId xmlns:a16="http://schemas.microsoft.com/office/drawing/2014/main" xmlns="" id="{7B6073B6-2471-4456-8F7A-423135135CEB}"/>
              </a:ext>
            </a:extLst>
          </p:cNvPr>
          <p:cNvGrpSpPr/>
          <p:nvPr/>
        </p:nvGrpSpPr>
        <p:grpSpPr>
          <a:xfrm>
            <a:off x="1477088" y="429018"/>
            <a:ext cx="583472" cy="476205"/>
            <a:chOff x="5564385" y="1233375"/>
            <a:chExt cx="583472" cy="476205"/>
          </a:xfrm>
        </p:grpSpPr>
        <p:sp>
          <p:nvSpPr>
            <p:cNvPr id="50" name="テキスト ボックス 214">
              <a:extLst>
                <a:ext uri="{FF2B5EF4-FFF2-40B4-BE49-F238E27FC236}">
                  <a16:creationId xmlns:a16="http://schemas.microsoft.com/office/drawing/2014/main" xmlns="" id="{F7AD2EE1-1C98-4251-9E8B-05BE2A460B4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241" y="1472468"/>
              <a:ext cx="34761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1" name="フリーフォーム 107">
              <a:extLst>
                <a:ext uri="{FF2B5EF4-FFF2-40B4-BE49-F238E27FC236}">
                  <a16:creationId xmlns:a16="http://schemas.microsoft.com/office/drawing/2014/main" xmlns="" id="{E4E515D9-9497-446C-9F57-A6E13312C28D}"/>
                </a:ext>
              </a:extLst>
            </p:cNvPr>
            <p:cNvSpPr/>
            <p:nvPr/>
          </p:nvSpPr>
          <p:spPr>
            <a:xfrm>
              <a:off x="5833051" y="1654315"/>
              <a:ext cx="223540" cy="53382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2" name="テキスト ボックス 214">
              <a:extLst>
                <a:ext uri="{FF2B5EF4-FFF2-40B4-BE49-F238E27FC236}">
                  <a16:creationId xmlns:a16="http://schemas.microsoft.com/office/drawing/2014/main" xmlns="" id="{90923BA8-B786-472D-8E05-9360AC99B1E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64385" y="1472468"/>
              <a:ext cx="3199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3" name="フリーフォーム 92">
              <a:extLst>
                <a:ext uri="{FF2B5EF4-FFF2-40B4-BE49-F238E27FC236}">
                  <a16:creationId xmlns:a16="http://schemas.microsoft.com/office/drawing/2014/main" xmlns="" id="{88ECBCA6-CA60-4E91-A380-76AC6678C332}"/>
                </a:ext>
              </a:extLst>
            </p:cNvPr>
            <p:cNvSpPr/>
            <p:nvPr/>
          </p:nvSpPr>
          <p:spPr>
            <a:xfrm>
              <a:off x="5618054" y="1653455"/>
              <a:ext cx="187938" cy="56125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4" name="フリーフォーム 93">
              <a:extLst>
                <a:ext uri="{FF2B5EF4-FFF2-40B4-BE49-F238E27FC236}">
                  <a16:creationId xmlns:a16="http://schemas.microsoft.com/office/drawing/2014/main" xmlns="" id="{6A8441EA-397C-425D-876E-9F9B04EEA9A9}"/>
                </a:ext>
              </a:extLst>
            </p:cNvPr>
            <p:cNvSpPr/>
            <p:nvPr/>
          </p:nvSpPr>
          <p:spPr>
            <a:xfrm>
              <a:off x="5614185" y="1419604"/>
              <a:ext cx="437733" cy="70641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5" name="テキスト ボックス 214">
              <a:extLst>
                <a:ext uri="{FF2B5EF4-FFF2-40B4-BE49-F238E27FC236}">
                  <a16:creationId xmlns:a16="http://schemas.microsoft.com/office/drawing/2014/main" xmlns="" id="{B4F80927-11BC-4A40-AAF7-82347CB1EBE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80024" y="1233375"/>
              <a:ext cx="42008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6" name="グループ化 55">
            <a:extLst>
              <a:ext uri="{FF2B5EF4-FFF2-40B4-BE49-F238E27FC236}">
                <a16:creationId xmlns:a16="http://schemas.microsoft.com/office/drawing/2014/main" xmlns="" id="{E4E8DB81-7CD7-40D8-9F02-588A517B34C8}"/>
              </a:ext>
            </a:extLst>
          </p:cNvPr>
          <p:cNvGrpSpPr/>
          <p:nvPr/>
        </p:nvGrpSpPr>
        <p:grpSpPr>
          <a:xfrm>
            <a:off x="2357411" y="1643474"/>
            <a:ext cx="583472" cy="476205"/>
            <a:chOff x="5564385" y="1233375"/>
            <a:chExt cx="583472" cy="476205"/>
          </a:xfrm>
        </p:grpSpPr>
        <p:sp>
          <p:nvSpPr>
            <p:cNvPr id="57" name="テキスト ボックス 214">
              <a:extLst>
                <a:ext uri="{FF2B5EF4-FFF2-40B4-BE49-F238E27FC236}">
                  <a16:creationId xmlns:a16="http://schemas.microsoft.com/office/drawing/2014/main" xmlns="" id="{36154B64-9E97-4F5B-83F1-7A87E86640E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241" y="1472468"/>
              <a:ext cx="34761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8" name="フリーフォーム 107">
              <a:extLst>
                <a:ext uri="{FF2B5EF4-FFF2-40B4-BE49-F238E27FC236}">
                  <a16:creationId xmlns:a16="http://schemas.microsoft.com/office/drawing/2014/main" xmlns="" id="{ABFD0AB9-6F4F-4683-AEEA-4AB41E784F8D}"/>
                </a:ext>
              </a:extLst>
            </p:cNvPr>
            <p:cNvSpPr/>
            <p:nvPr/>
          </p:nvSpPr>
          <p:spPr>
            <a:xfrm>
              <a:off x="5833051" y="1654315"/>
              <a:ext cx="223540" cy="53382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9" name="テキスト ボックス 214">
              <a:extLst>
                <a:ext uri="{FF2B5EF4-FFF2-40B4-BE49-F238E27FC236}">
                  <a16:creationId xmlns:a16="http://schemas.microsoft.com/office/drawing/2014/main" xmlns="" id="{F4A0A8B2-0FC4-4313-AF80-D2A2A523D9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64385" y="1472468"/>
              <a:ext cx="3199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0" name="フリーフォーム 92">
              <a:extLst>
                <a:ext uri="{FF2B5EF4-FFF2-40B4-BE49-F238E27FC236}">
                  <a16:creationId xmlns:a16="http://schemas.microsoft.com/office/drawing/2014/main" xmlns="" id="{E8BB1990-D937-4620-8617-25DE847A5B3A}"/>
                </a:ext>
              </a:extLst>
            </p:cNvPr>
            <p:cNvSpPr/>
            <p:nvPr/>
          </p:nvSpPr>
          <p:spPr>
            <a:xfrm>
              <a:off x="5618054" y="1653455"/>
              <a:ext cx="187938" cy="56125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1" name="フリーフォーム 93">
              <a:extLst>
                <a:ext uri="{FF2B5EF4-FFF2-40B4-BE49-F238E27FC236}">
                  <a16:creationId xmlns:a16="http://schemas.microsoft.com/office/drawing/2014/main" xmlns="" id="{8BC67463-6E88-4316-967E-116F9FF61FFA}"/>
                </a:ext>
              </a:extLst>
            </p:cNvPr>
            <p:cNvSpPr/>
            <p:nvPr/>
          </p:nvSpPr>
          <p:spPr>
            <a:xfrm>
              <a:off x="5614185" y="1419604"/>
              <a:ext cx="437733" cy="70641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2" name="テキスト ボックス 214">
              <a:extLst>
                <a:ext uri="{FF2B5EF4-FFF2-40B4-BE49-F238E27FC236}">
                  <a16:creationId xmlns:a16="http://schemas.microsoft.com/office/drawing/2014/main" xmlns="" id="{4BE582EC-7106-49B3-A14A-5B26F2EF8B5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80024" y="1233375"/>
              <a:ext cx="42008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3" name="グループ化 62">
            <a:extLst>
              <a:ext uri="{FF2B5EF4-FFF2-40B4-BE49-F238E27FC236}">
                <a16:creationId xmlns:a16="http://schemas.microsoft.com/office/drawing/2014/main" xmlns="" id="{2D61D95D-6E40-4155-9638-99121214B8EE}"/>
              </a:ext>
            </a:extLst>
          </p:cNvPr>
          <p:cNvGrpSpPr/>
          <p:nvPr/>
        </p:nvGrpSpPr>
        <p:grpSpPr>
          <a:xfrm>
            <a:off x="3247200" y="1643474"/>
            <a:ext cx="583472" cy="476205"/>
            <a:chOff x="5564385" y="1233375"/>
            <a:chExt cx="583472" cy="476205"/>
          </a:xfrm>
        </p:grpSpPr>
        <p:sp>
          <p:nvSpPr>
            <p:cNvPr id="64" name="テキスト ボックス 214">
              <a:extLst>
                <a:ext uri="{FF2B5EF4-FFF2-40B4-BE49-F238E27FC236}">
                  <a16:creationId xmlns:a16="http://schemas.microsoft.com/office/drawing/2014/main" xmlns="" id="{7AE26478-B887-4E3B-B2BE-61E142FC309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241" y="1472468"/>
              <a:ext cx="34761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5" name="フリーフォーム 107">
              <a:extLst>
                <a:ext uri="{FF2B5EF4-FFF2-40B4-BE49-F238E27FC236}">
                  <a16:creationId xmlns:a16="http://schemas.microsoft.com/office/drawing/2014/main" xmlns="" id="{BCBF22D6-14AD-4369-90D6-45316749E572}"/>
                </a:ext>
              </a:extLst>
            </p:cNvPr>
            <p:cNvSpPr/>
            <p:nvPr/>
          </p:nvSpPr>
          <p:spPr>
            <a:xfrm>
              <a:off x="5833051" y="1654315"/>
              <a:ext cx="223540" cy="53382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6" name="テキスト ボックス 214">
              <a:extLst>
                <a:ext uri="{FF2B5EF4-FFF2-40B4-BE49-F238E27FC236}">
                  <a16:creationId xmlns:a16="http://schemas.microsoft.com/office/drawing/2014/main" xmlns="" id="{1A29D865-5737-463C-9FBB-5C2A3A4CA74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64385" y="1472468"/>
              <a:ext cx="3199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7" name="フリーフォーム 92">
              <a:extLst>
                <a:ext uri="{FF2B5EF4-FFF2-40B4-BE49-F238E27FC236}">
                  <a16:creationId xmlns:a16="http://schemas.microsoft.com/office/drawing/2014/main" xmlns="" id="{F52099F1-71F9-4908-8FB1-C695616456F5}"/>
                </a:ext>
              </a:extLst>
            </p:cNvPr>
            <p:cNvSpPr/>
            <p:nvPr/>
          </p:nvSpPr>
          <p:spPr>
            <a:xfrm>
              <a:off x="5618054" y="1653455"/>
              <a:ext cx="187938" cy="56125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8" name="フリーフォーム 93">
              <a:extLst>
                <a:ext uri="{FF2B5EF4-FFF2-40B4-BE49-F238E27FC236}">
                  <a16:creationId xmlns:a16="http://schemas.microsoft.com/office/drawing/2014/main" xmlns="" id="{7FD013AF-70C6-4A59-A095-CF2F63C07B05}"/>
                </a:ext>
              </a:extLst>
            </p:cNvPr>
            <p:cNvSpPr/>
            <p:nvPr/>
          </p:nvSpPr>
          <p:spPr>
            <a:xfrm>
              <a:off x="5614185" y="1419604"/>
              <a:ext cx="437733" cy="70641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9" name="テキスト ボックス 214">
              <a:extLst>
                <a:ext uri="{FF2B5EF4-FFF2-40B4-BE49-F238E27FC236}">
                  <a16:creationId xmlns:a16="http://schemas.microsoft.com/office/drawing/2014/main" xmlns="" id="{C79593A5-8E34-40CE-9CE8-9DBC5838E9B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80024" y="1233375"/>
              <a:ext cx="42008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xmlns="" id="{624E9616-9878-43B7-AC4A-4F25CCEBE975}"/>
              </a:ext>
            </a:extLst>
          </p:cNvPr>
          <p:cNvGrpSpPr/>
          <p:nvPr/>
        </p:nvGrpSpPr>
        <p:grpSpPr>
          <a:xfrm>
            <a:off x="4124196" y="775833"/>
            <a:ext cx="583472" cy="476205"/>
            <a:chOff x="5564385" y="1233375"/>
            <a:chExt cx="583472" cy="476205"/>
          </a:xfrm>
        </p:grpSpPr>
        <p:sp>
          <p:nvSpPr>
            <p:cNvPr id="71" name="テキスト ボックス 214">
              <a:extLst>
                <a:ext uri="{FF2B5EF4-FFF2-40B4-BE49-F238E27FC236}">
                  <a16:creationId xmlns:a16="http://schemas.microsoft.com/office/drawing/2014/main" xmlns="" id="{53CB960B-1342-4919-8FFE-F1B6AE72E59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800241" y="1472468"/>
              <a:ext cx="34761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2" name="フリーフォーム 107">
              <a:extLst>
                <a:ext uri="{FF2B5EF4-FFF2-40B4-BE49-F238E27FC236}">
                  <a16:creationId xmlns:a16="http://schemas.microsoft.com/office/drawing/2014/main" xmlns="" id="{E2CD74FC-CBAB-41C2-9AF1-65D883BD45D5}"/>
                </a:ext>
              </a:extLst>
            </p:cNvPr>
            <p:cNvSpPr/>
            <p:nvPr/>
          </p:nvSpPr>
          <p:spPr>
            <a:xfrm>
              <a:off x="5833051" y="1654315"/>
              <a:ext cx="223540" cy="53382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3" name="テキスト ボックス 214">
              <a:extLst>
                <a:ext uri="{FF2B5EF4-FFF2-40B4-BE49-F238E27FC236}">
                  <a16:creationId xmlns:a16="http://schemas.microsoft.com/office/drawing/2014/main" xmlns="" id="{031D2214-49D8-4213-BF3F-FB5A9C677FE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64385" y="1472468"/>
              <a:ext cx="3199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4" name="フリーフォーム 92">
              <a:extLst>
                <a:ext uri="{FF2B5EF4-FFF2-40B4-BE49-F238E27FC236}">
                  <a16:creationId xmlns:a16="http://schemas.microsoft.com/office/drawing/2014/main" xmlns="" id="{6FC92E14-050A-46C1-82D2-D34B372A2BCF}"/>
                </a:ext>
              </a:extLst>
            </p:cNvPr>
            <p:cNvSpPr/>
            <p:nvPr/>
          </p:nvSpPr>
          <p:spPr>
            <a:xfrm>
              <a:off x="5618054" y="1653455"/>
              <a:ext cx="187938" cy="56125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5" name="フリーフォーム 93">
              <a:extLst>
                <a:ext uri="{FF2B5EF4-FFF2-40B4-BE49-F238E27FC236}">
                  <a16:creationId xmlns:a16="http://schemas.microsoft.com/office/drawing/2014/main" xmlns="" id="{550AF201-1194-4322-B160-295739A4EEE7}"/>
                </a:ext>
              </a:extLst>
            </p:cNvPr>
            <p:cNvSpPr/>
            <p:nvPr/>
          </p:nvSpPr>
          <p:spPr>
            <a:xfrm>
              <a:off x="5614185" y="1419604"/>
              <a:ext cx="437733" cy="70641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76" name="テキスト ボックス 214">
              <a:extLst>
                <a:ext uri="{FF2B5EF4-FFF2-40B4-BE49-F238E27FC236}">
                  <a16:creationId xmlns:a16="http://schemas.microsoft.com/office/drawing/2014/main" xmlns="" id="{6798A403-9557-4DB1-A657-964B542D72E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680024" y="1233375"/>
              <a:ext cx="42008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xmlns="" id="{FFB3ADDA-EA91-4E56-88BC-C869EECFEBD2}"/>
              </a:ext>
            </a:extLst>
          </p:cNvPr>
          <p:cNvSpPr txBox="1"/>
          <p:nvPr/>
        </p:nvSpPr>
        <p:spPr>
          <a:xfrm>
            <a:off x="90634" y="3149128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g</a:t>
            </a:r>
            <a:r>
              <a:rPr lang="en-US" altLang="ja-JP" sz="1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</a:t>
            </a:r>
            <a:endParaRPr lang="ja-JP" altLang="en-US" sz="10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xmlns="" id="{B90EF2C6-8D9C-42EA-A46E-DEE1EB5F8D98}"/>
              </a:ext>
            </a:extLst>
          </p:cNvPr>
          <p:cNvSpPr txBox="1"/>
          <p:nvPr/>
        </p:nvSpPr>
        <p:spPr>
          <a:xfrm>
            <a:off x="4925481" y="5945134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** p&lt;0.01</a:t>
            </a: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xmlns="" id="{4A037BD1-3C30-4DB1-BB1F-D5F6429EC496}"/>
              </a:ext>
            </a:extLst>
          </p:cNvPr>
          <p:cNvSpPr txBox="1"/>
          <p:nvPr/>
        </p:nvSpPr>
        <p:spPr>
          <a:xfrm>
            <a:off x="159563" y="2841351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xmlns="" id="{496985C1-3DD9-4AEB-9872-A7CC169888A1}"/>
              </a:ext>
            </a:extLst>
          </p:cNvPr>
          <p:cNvSpPr txBox="1"/>
          <p:nvPr/>
        </p:nvSpPr>
        <p:spPr>
          <a:xfrm>
            <a:off x="2269330" y="2841350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xmlns="" id="{20ADF5DC-D388-4D26-94AE-2C7E6F823620}"/>
              </a:ext>
            </a:extLst>
          </p:cNvPr>
          <p:cNvSpPr txBox="1"/>
          <p:nvPr/>
        </p:nvSpPr>
        <p:spPr>
          <a:xfrm>
            <a:off x="4505585" y="2841350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xmlns="" id="{594A0008-FB55-417C-A3B4-ED83D6F93FAF}"/>
              </a:ext>
            </a:extLst>
          </p:cNvPr>
          <p:cNvSpPr txBox="1"/>
          <p:nvPr/>
        </p:nvSpPr>
        <p:spPr>
          <a:xfrm>
            <a:off x="180531" y="4858824"/>
            <a:ext cx="3177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xmlns="" id="{60E9EF8E-71BD-4202-B8C7-7F2BBF65655E}"/>
              </a:ext>
            </a:extLst>
          </p:cNvPr>
          <p:cNvSpPr txBox="1"/>
          <p:nvPr/>
        </p:nvSpPr>
        <p:spPr>
          <a:xfrm>
            <a:off x="2507271" y="4858823"/>
            <a:ext cx="2957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xmlns="" id="{96B8A458-5C20-48FB-B377-45E2C5FDFC1D}"/>
              </a:ext>
            </a:extLst>
          </p:cNvPr>
          <p:cNvSpPr txBox="1"/>
          <p:nvPr/>
        </p:nvSpPr>
        <p:spPr>
          <a:xfrm>
            <a:off x="386664" y="4414835"/>
            <a:ext cx="1903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    HDM-     HDM-    HDM-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placebo     CAM     EM900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xmlns="" id="{6A2FFE78-3160-4C70-9EB6-0C586127E176}"/>
              </a:ext>
            </a:extLst>
          </p:cNvPr>
          <p:cNvSpPr txBox="1"/>
          <p:nvPr/>
        </p:nvSpPr>
        <p:spPr>
          <a:xfrm>
            <a:off x="2493068" y="4413114"/>
            <a:ext cx="1960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     HDM-      HDM-     HDM-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placebo      CAM      EM900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xmlns="" id="{C638109F-1414-4501-BD5D-15CF69CEDA51}"/>
              </a:ext>
            </a:extLst>
          </p:cNvPr>
          <p:cNvSpPr txBox="1"/>
          <p:nvPr/>
        </p:nvSpPr>
        <p:spPr>
          <a:xfrm>
            <a:off x="4724118" y="4413114"/>
            <a:ext cx="19319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     HDM-     HDM-     HDM-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placebo     CAM      EM900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xmlns="" id="{F133A0E4-CDCB-4357-988C-A71C320C8799}"/>
              </a:ext>
            </a:extLst>
          </p:cNvPr>
          <p:cNvSpPr txBox="1"/>
          <p:nvPr/>
        </p:nvSpPr>
        <p:spPr>
          <a:xfrm>
            <a:off x="345513" y="6431684"/>
            <a:ext cx="18742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control    HDM-    HDM-    HDM-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placebo    CAM     EM900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xmlns="" id="{F0AD0903-BAA8-4059-BEDA-0E7A71783CCC}"/>
              </a:ext>
            </a:extLst>
          </p:cNvPr>
          <p:cNvSpPr txBox="1"/>
          <p:nvPr/>
        </p:nvSpPr>
        <p:spPr>
          <a:xfrm>
            <a:off x="2699335" y="6431684"/>
            <a:ext cx="1903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    HDM-     HDM-    HDM-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placebo     CAM     EM900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xmlns="" id="{026A29F5-2CA2-458F-AE72-24C1AE5B36CF}"/>
              </a:ext>
            </a:extLst>
          </p:cNvPr>
          <p:cNvSpPr txBox="1"/>
          <p:nvPr/>
        </p:nvSpPr>
        <p:spPr>
          <a:xfrm>
            <a:off x="2226237" y="3153981"/>
            <a:ext cx="4972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err="1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g</a:t>
            </a:r>
            <a:r>
              <a:rPr lang="en-US" altLang="ja-JP" sz="1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</a:t>
            </a:r>
            <a:endParaRPr lang="ja-JP" altLang="en-US" sz="10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xmlns="" id="{70370D74-EC20-49E5-8637-0B4BE6E43F6A}"/>
              </a:ext>
            </a:extLst>
          </p:cNvPr>
          <p:cNvSpPr txBox="1"/>
          <p:nvPr/>
        </p:nvSpPr>
        <p:spPr>
          <a:xfrm>
            <a:off x="137179" y="5160677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g</a:t>
            </a:r>
            <a:r>
              <a:rPr lang="en-US" altLang="ja-JP" sz="1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</a:t>
            </a:r>
            <a:endParaRPr lang="ja-JP" altLang="en-US" sz="10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xmlns="" id="{F143A70E-CC9E-4AAB-BD5B-A6BC1765ADD6}"/>
              </a:ext>
            </a:extLst>
          </p:cNvPr>
          <p:cNvSpPr txBox="1"/>
          <p:nvPr/>
        </p:nvSpPr>
        <p:spPr>
          <a:xfrm>
            <a:off x="2477600" y="5165224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g</a:t>
            </a:r>
            <a:r>
              <a:rPr lang="en-US" altLang="ja-JP" sz="1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</a:t>
            </a:r>
            <a:endParaRPr lang="ja-JP" altLang="en-US" sz="10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xmlns="" id="{F6554C9B-96F4-4B28-ABD9-BA334AD7D3BE}"/>
              </a:ext>
            </a:extLst>
          </p:cNvPr>
          <p:cNvSpPr txBox="1"/>
          <p:nvPr/>
        </p:nvSpPr>
        <p:spPr>
          <a:xfrm>
            <a:off x="4439620" y="3145737"/>
            <a:ext cx="4972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ng/ml</a:t>
            </a:r>
            <a:endParaRPr lang="ja-JP" altLang="en-US" sz="10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98" name="グループ化 97">
            <a:extLst>
              <a:ext uri="{FF2B5EF4-FFF2-40B4-BE49-F238E27FC236}">
                <a16:creationId xmlns:a16="http://schemas.microsoft.com/office/drawing/2014/main" xmlns="" id="{623E38AC-DFAB-498B-95E8-6256B06FD887}"/>
              </a:ext>
            </a:extLst>
          </p:cNvPr>
          <p:cNvGrpSpPr/>
          <p:nvPr/>
        </p:nvGrpSpPr>
        <p:grpSpPr>
          <a:xfrm>
            <a:off x="1054585" y="3215876"/>
            <a:ext cx="939800" cy="428102"/>
            <a:chOff x="-785874" y="5785768"/>
            <a:chExt cx="939800" cy="428102"/>
          </a:xfrm>
        </p:grpSpPr>
        <p:sp>
          <p:nvSpPr>
            <p:cNvPr id="99" name="テキスト ボックス 214">
              <a:extLst>
                <a:ext uri="{FF2B5EF4-FFF2-40B4-BE49-F238E27FC236}">
                  <a16:creationId xmlns:a16="http://schemas.microsoft.com/office/drawing/2014/main" xmlns="" id="{1AABDFB0-A6A2-4B18-A9D4-45685D69684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709058" y="5939595"/>
              <a:ext cx="32286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0" name="テキスト ボックス 214">
              <a:extLst>
                <a:ext uri="{FF2B5EF4-FFF2-40B4-BE49-F238E27FC236}">
                  <a16:creationId xmlns:a16="http://schemas.microsoft.com/office/drawing/2014/main" xmlns="" id="{602CAE8B-34F9-4D1E-83B2-441CEBCA70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460490" y="5785768"/>
              <a:ext cx="3134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1" name="フリーフォーム 55">
              <a:extLst>
                <a:ext uri="{FF2B5EF4-FFF2-40B4-BE49-F238E27FC236}">
                  <a16:creationId xmlns:a16="http://schemas.microsoft.com/office/drawing/2014/main" xmlns="" id="{0AE60195-15B8-41E7-AA60-5275645ECBB3}"/>
                </a:ext>
              </a:extLst>
            </p:cNvPr>
            <p:cNvSpPr/>
            <p:nvPr/>
          </p:nvSpPr>
          <p:spPr>
            <a:xfrm>
              <a:off x="-785874" y="6122298"/>
              <a:ext cx="449066" cy="91572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2" name="フリーフォーム 56">
              <a:extLst>
                <a:ext uri="{FF2B5EF4-FFF2-40B4-BE49-F238E27FC236}">
                  <a16:creationId xmlns:a16="http://schemas.microsoft.com/office/drawing/2014/main" xmlns="" id="{E844558B-296C-4FF8-B5F0-05FABF454A8E}"/>
                </a:ext>
              </a:extLst>
            </p:cNvPr>
            <p:cNvSpPr/>
            <p:nvPr/>
          </p:nvSpPr>
          <p:spPr>
            <a:xfrm>
              <a:off x="-785874" y="5971766"/>
              <a:ext cx="939800" cy="87298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3" name="フリーフォーム 55">
              <a:extLst>
                <a:ext uri="{FF2B5EF4-FFF2-40B4-BE49-F238E27FC236}">
                  <a16:creationId xmlns:a16="http://schemas.microsoft.com/office/drawing/2014/main" xmlns="" id="{A2FF3241-2D6A-402E-9CDA-4D495C9637A6}"/>
                </a:ext>
              </a:extLst>
            </p:cNvPr>
            <p:cNvSpPr/>
            <p:nvPr/>
          </p:nvSpPr>
          <p:spPr>
            <a:xfrm>
              <a:off x="-295143" y="6122298"/>
              <a:ext cx="449067" cy="87298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4" name="テキスト ボックス 214">
              <a:extLst>
                <a:ext uri="{FF2B5EF4-FFF2-40B4-BE49-F238E27FC236}">
                  <a16:creationId xmlns:a16="http://schemas.microsoft.com/office/drawing/2014/main" xmlns="" id="{428AF58D-CFC0-48B2-8D64-52D99673845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219687" y="5950503"/>
              <a:ext cx="3466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5" name="グループ化 104">
            <a:extLst>
              <a:ext uri="{FF2B5EF4-FFF2-40B4-BE49-F238E27FC236}">
                <a16:creationId xmlns:a16="http://schemas.microsoft.com/office/drawing/2014/main" xmlns="" id="{C065B9EA-E58D-4548-8702-9889CF2A40F5}"/>
              </a:ext>
            </a:extLst>
          </p:cNvPr>
          <p:cNvGrpSpPr/>
          <p:nvPr/>
        </p:nvGrpSpPr>
        <p:grpSpPr>
          <a:xfrm>
            <a:off x="3211512" y="3207615"/>
            <a:ext cx="939800" cy="402514"/>
            <a:chOff x="-785874" y="5811356"/>
            <a:chExt cx="939800" cy="402514"/>
          </a:xfrm>
        </p:grpSpPr>
        <p:sp>
          <p:nvSpPr>
            <p:cNvPr id="106" name="テキスト ボックス 214">
              <a:extLst>
                <a:ext uri="{FF2B5EF4-FFF2-40B4-BE49-F238E27FC236}">
                  <a16:creationId xmlns:a16="http://schemas.microsoft.com/office/drawing/2014/main" xmlns="" id="{839990E3-0D8B-4E2F-9B2E-821CD3F219E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719116" y="5950503"/>
              <a:ext cx="32286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7" name="テキスト ボックス 214">
              <a:extLst>
                <a:ext uri="{FF2B5EF4-FFF2-40B4-BE49-F238E27FC236}">
                  <a16:creationId xmlns:a16="http://schemas.microsoft.com/office/drawing/2014/main" xmlns="" id="{9E834FDE-8B5B-40A0-8EA1-F05EB7BCF60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428467" y="5811356"/>
              <a:ext cx="31347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9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**</a:t>
              </a:r>
              <a:endParaRPr lang="ja-JP" altLang="en-US" sz="9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8" name="フリーフォーム 55">
              <a:extLst>
                <a:ext uri="{FF2B5EF4-FFF2-40B4-BE49-F238E27FC236}">
                  <a16:creationId xmlns:a16="http://schemas.microsoft.com/office/drawing/2014/main" xmlns="" id="{376D99AA-7004-4086-B83F-6016FAE860E7}"/>
                </a:ext>
              </a:extLst>
            </p:cNvPr>
            <p:cNvSpPr/>
            <p:nvPr/>
          </p:nvSpPr>
          <p:spPr>
            <a:xfrm>
              <a:off x="-785874" y="6122298"/>
              <a:ext cx="449066" cy="91572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9" name="フリーフォーム 56">
              <a:extLst>
                <a:ext uri="{FF2B5EF4-FFF2-40B4-BE49-F238E27FC236}">
                  <a16:creationId xmlns:a16="http://schemas.microsoft.com/office/drawing/2014/main" xmlns="" id="{A40020E8-5222-4DC6-9AEE-4A11D4B5AE3C}"/>
                </a:ext>
              </a:extLst>
            </p:cNvPr>
            <p:cNvSpPr/>
            <p:nvPr/>
          </p:nvSpPr>
          <p:spPr>
            <a:xfrm>
              <a:off x="-785874" y="5971766"/>
              <a:ext cx="939800" cy="87298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0" name="フリーフォーム 55">
              <a:extLst>
                <a:ext uri="{FF2B5EF4-FFF2-40B4-BE49-F238E27FC236}">
                  <a16:creationId xmlns:a16="http://schemas.microsoft.com/office/drawing/2014/main" xmlns="" id="{D7A501E8-E60A-4948-8A17-D20A25544C8F}"/>
                </a:ext>
              </a:extLst>
            </p:cNvPr>
            <p:cNvSpPr/>
            <p:nvPr/>
          </p:nvSpPr>
          <p:spPr>
            <a:xfrm>
              <a:off x="-295143" y="6122298"/>
              <a:ext cx="449067" cy="87298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1" name="テキスト ボックス 214">
              <a:extLst>
                <a:ext uri="{FF2B5EF4-FFF2-40B4-BE49-F238E27FC236}">
                  <a16:creationId xmlns:a16="http://schemas.microsoft.com/office/drawing/2014/main" xmlns="" id="{7F0317BB-8B35-4617-9E57-30EDBD5E1A0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219687" y="5950503"/>
              <a:ext cx="3466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2" name="グループ化 111">
            <a:extLst>
              <a:ext uri="{FF2B5EF4-FFF2-40B4-BE49-F238E27FC236}">
                <a16:creationId xmlns:a16="http://schemas.microsoft.com/office/drawing/2014/main" xmlns="" id="{06867914-97A2-48F4-8C67-5363D819A627}"/>
              </a:ext>
            </a:extLst>
          </p:cNvPr>
          <p:cNvGrpSpPr/>
          <p:nvPr/>
        </p:nvGrpSpPr>
        <p:grpSpPr>
          <a:xfrm>
            <a:off x="5408667" y="3226431"/>
            <a:ext cx="939800" cy="413273"/>
            <a:chOff x="-785874" y="5800597"/>
            <a:chExt cx="939800" cy="413273"/>
          </a:xfrm>
        </p:grpSpPr>
        <p:sp>
          <p:nvSpPr>
            <p:cNvPr id="113" name="テキスト ボックス 214">
              <a:extLst>
                <a:ext uri="{FF2B5EF4-FFF2-40B4-BE49-F238E27FC236}">
                  <a16:creationId xmlns:a16="http://schemas.microsoft.com/office/drawing/2014/main" xmlns="" id="{C171666A-88B8-4656-B9B2-C7117C12FFB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705635" y="5939678"/>
              <a:ext cx="34661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14" name="テキスト ボックス 214">
              <a:extLst>
                <a:ext uri="{FF2B5EF4-FFF2-40B4-BE49-F238E27FC236}">
                  <a16:creationId xmlns:a16="http://schemas.microsoft.com/office/drawing/2014/main" xmlns="" id="{65011AC6-0A8D-4A54-A163-D5FA23EB70C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460529" y="5800597"/>
              <a:ext cx="3134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15" name="フリーフォーム 55">
              <a:extLst>
                <a:ext uri="{FF2B5EF4-FFF2-40B4-BE49-F238E27FC236}">
                  <a16:creationId xmlns:a16="http://schemas.microsoft.com/office/drawing/2014/main" xmlns="" id="{61EA5350-42FE-44FF-A614-3A06C7525543}"/>
                </a:ext>
              </a:extLst>
            </p:cNvPr>
            <p:cNvSpPr/>
            <p:nvPr/>
          </p:nvSpPr>
          <p:spPr>
            <a:xfrm>
              <a:off x="-785874" y="6122298"/>
              <a:ext cx="449066" cy="91572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6" name="フリーフォーム 56">
              <a:extLst>
                <a:ext uri="{FF2B5EF4-FFF2-40B4-BE49-F238E27FC236}">
                  <a16:creationId xmlns:a16="http://schemas.microsoft.com/office/drawing/2014/main" xmlns="" id="{84FD5AB5-D98A-496C-8DE9-1FF520749829}"/>
                </a:ext>
              </a:extLst>
            </p:cNvPr>
            <p:cNvSpPr/>
            <p:nvPr/>
          </p:nvSpPr>
          <p:spPr>
            <a:xfrm>
              <a:off x="-785874" y="5971766"/>
              <a:ext cx="939800" cy="87298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7" name="フリーフォーム 55">
              <a:extLst>
                <a:ext uri="{FF2B5EF4-FFF2-40B4-BE49-F238E27FC236}">
                  <a16:creationId xmlns:a16="http://schemas.microsoft.com/office/drawing/2014/main" xmlns="" id="{FF9A7365-1E38-48F3-A205-58BD6B284D72}"/>
                </a:ext>
              </a:extLst>
            </p:cNvPr>
            <p:cNvSpPr/>
            <p:nvPr/>
          </p:nvSpPr>
          <p:spPr>
            <a:xfrm>
              <a:off x="-295143" y="6122298"/>
              <a:ext cx="449067" cy="87298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18" name="テキスト ボックス 214">
              <a:extLst>
                <a:ext uri="{FF2B5EF4-FFF2-40B4-BE49-F238E27FC236}">
                  <a16:creationId xmlns:a16="http://schemas.microsoft.com/office/drawing/2014/main" xmlns="" id="{8DDD8F20-D266-409E-8858-5F987EDD366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214957" y="5946626"/>
              <a:ext cx="3466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19" name="グループ化 118">
            <a:extLst>
              <a:ext uri="{FF2B5EF4-FFF2-40B4-BE49-F238E27FC236}">
                <a16:creationId xmlns:a16="http://schemas.microsoft.com/office/drawing/2014/main" xmlns="" id="{FB0CB679-31B4-48D5-B79E-D4ACEC46E99C}"/>
              </a:ext>
            </a:extLst>
          </p:cNvPr>
          <p:cNvGrpSpPr/>
          <p:nvPr/>
        </p:nvGrpSpPr>
        <p:grpSpPr>
          <a:xfrm>
            <a:off x="1020899" y="5206356"/>
            <a:ext cx="939800" cy="422335"/>
            <a:chOff x="-785874" y="5791535"/>
            <a:chExt cx="939800" cy="422335"/>
          </a:xfrm>
        </p:grpSpPr>
        <p:sp>
          <p:nvSpPr>
            <p:cNvPr id="120" name="テキスト ボックス 214">
              <a:extLst>
                <a:ext uri="{FF2B5EF4-FFF2-40B4-BE49-F238E27FC236}">
                  <a16:creationId xmlns:a16="http://schemas.microsoft.com/office/drawing/2014/main" xmlns="" id="{233C3B02-E4EA-403D-A4F2-9AFC93BE7D0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708752" y="5943577"/>
              <a:ext cx="32286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21" name="テキスト ボックス 214">
              <a:extLst>
                <a:ext uri="{FF2B5EF4-FFF2-40B4-BE49-F238E27FC236}">
                  <a16:creationId xmlns:a16="http://schemas.microsoft.com/office/drawing/2014/main" xmlns="" id="{54E546B4-4675-48C2-B0A8-9F549D65F7B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465503" y="5791535"/>
              <a:ext cx="3134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22" name="フリーフォーム 55">
              <a:extLst>
                <a:ext uri="{FF2B5EF4-FFF2-40B4-BE49-F238E27FC236}">
                  <a16:creationId xmlns:a16="http://schemas.microsoft.com/office/drawing/2014/main" xmlns="" id="{AC79A5F6-CE71-4258-9F6B-0545559E5CC6}"/>
                </a:ext>
              </a:extLst>
            </p:cNvPr>
            <p:cNvSpPr/>
            <p:nvPr/>
          </p:nvSpPr>
          <p:spPr>
            <a:xfrm>
              <a:off x="-785874" y="6122298"/>
              <a:ext cx="449066" cy="91572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3" name="フリーフォーム 56">
              <a:extLst>
                <a:ext uri="{FF2B5EF4-FFF2-40B4-BE49-F238E27FC236}">
                  <a16:creationId xmlns:a16="http://schemas.microsoft.com/office/drawing/2014/main" xmlns="" id="{5C1D19BC-E303-4730-A861-F7F5E7652578}"/>
                </a:ext>
              </a:extLst>
            </p:cNvPr>
            <p:cNvSpPr/>
            <p:nvPr/>
          </p:nvSpPr>
          <p:spPr>
            <a:xfrm>
              <a:off x="-785874" y="5971766"/>
              <a:ext cx="939800" cy="87298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4" name="フリーフォーム 55">
              <a:extLst>
                <a:ext uri="{FF2B5EF4-FFF2-40B4-BE49-F238E27FC236}">
                  <a16:creationId xmlns:a16="http://schemas.microsoft.com/office/drawing/2014/main" xmlns="" id="{D82FFBE8-C87E-4B24-9911-232230AC1665}"/>
                </a:ext>
              </a:extLst>
            </p:cNvPr>
            <p:cNvSpPr/>
            <p:nvPr/>
          </p:nvSpPr>
          <p:spPr>
            <a:xfrm>
              <a:off x="-295143" y="6122298"/>
              <a:ext cx="449067" cy="87298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25" name="テキスト ボックス 214">
              <a:extLst>
                <a:ext uri="{FF2B5EF4-FFF2-40B4-BE49-F238E27FC236}">
                  <a16:creationId xmlns:a16="http://schemas.microsoft.com/office/drawing/2014/main" xmlns="" id="{98EBD8E3-803B-470A-B682-80690CB0A1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219687" y="5950503"/>
              <a:ext cx="3466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6" name="グループ化 125">
            <a:extLst>
              <a:ext uri="{FF2B5EF4-FFF2-40B4-BE49-F238E27FC236}">
                <a16:creationId xmlns:a16="http://schemas.microsoft.com/office/drawing/2014/main" xmlns="" id="{61BCF0A3-9C05-4E2E-AAAB-1ED12F60A5C2}"/>
              </a:ext>
            </a:extLst>
          </p:cNvPr>
          <p:cNvGrpSpPr/>
          <p:nvPr/>
        </p:nvGrpSpPr>
        <p:grpSpPr>
          <a:xfrm>
            <a:off x="3359439" y="5278922"/>
            <a:ext cx="939800" cy="416254"/>
            <a:chOff x="-785874" y="5797616"/>
            <a:chExt cx="939800" cy="416254"/>
          </a:xfrm>
        </p:grpSpPr>
        <p:sp>
          <p:nvSpPr>
            <p:cNvPr id="127" name="テキスト ボックス 214">
              <a:extLst>
                <a:ext uri="{FF2B5EF4-FFF2-40B4-BE49-F238E27FC236}">
                  <a16:creationId xmlns:a16="http://schemas.microsoft.com/office/drawing/2014/main" xmlns="" id="{1D8DBC6B-E936-4017-B54B-8B55A0A3AB9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714239" y="5950503"/>
              <a:ext cx="32286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28" name="テキスト ボックス 214">
              <a:extLst>
                <a:ext uri="{FF2B5EF4-FFF2-40B4-BE49-F238E27FC236}">
                  <a16:creationId xmlns:a16="http://schemas.microsoft.com/office/drawing/2014/main" xmlns="" id="{E389E3E7-D81D-458E-8F47-2322F6F6AF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451878" y="5797616"/>
              <a:ext cx="3134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29" name="フリーフォーム 55">
              <a:extLst>
                <a:ext uri="{FF2B5EF4-FFF2-40B4-BE49-F238E27FC236}">
                  <a16:creationId xmlns:a16="http://schemas.microsoft.com/office/drawing/2014/main" xmlns="" id="{7192ED53-A5A8-4D53-9740-9344620390D7}"/>
                </a:ext>
              </a:extLst>
            </p:cNvPr>
            <p:cNvSpPr/>
            <p:nvPr/>
          </p:nvSpPr>
          <p:spPr>
            <a:xfrm>
              <a:off x="-785874" y="6122298"/>
              <a:ext cx="449066" cy="91572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0" name="フリーフォーム 56">
              <a:extLst>
                <a:ext uri="{FF2B5EF4-FFF2-40B4-BE49-F238E27FC236}">
                  <a16:creationId xmlns:a16="http://schemas.microsoft.com/office/drawing/2014/main" xmlns="" id="{186B49DD-6E0F-4D4C-A3E0-DC27820A25E5}"/>
                </a:ext>
              </a:extLst>
            </p:cNvPr>
            <p:cNvSpPr/>
            <p:nvPr/>
          </p:nvSpPr>
          <p:spPr>
            <a:xfrm>
              <a:off x="-785874" y="5971766"/>
              <a:ext cx="939800" cy="87298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1" name="フリーフォーム 55">
              <a:extLst>
                <a:ext uri="{FF2B5EF4-FFF2-40B4-BE49-F238E27FC236}">
                  <a16:creationId xmlns:a16="http://schemas.microsoft.com/office/drawing/2014/main" xmlns="" id="{DB0F9375-472B-4C46-BAC4-A60056F38A9C}"/>
                </a:ext>
              </a:extLst>
            </p:cNvPr>
            <p:cNvSpPr/>
            <p:nvPr/>
          </p:nvSpPr>
          <p:spPr>
            <a:xfrm>
              <a:off x="-295143" y="6122298"/>
              <a:ext cx="449067" cy="87298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32" name="テキスト ボックス 214">
              <a:extLst>
                <a:ext uri="{FF2B5EF4-FFF2-40B4-BE49-F238E27FC236}">
                  <a16:creationId xmlns:a16="http://schemas.microsoft.com/office/drawing/2014/main" xmlns="" id="{19E922EE-3205-40F9-AB90-BDF41FEA622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-219687" y="5950503"/>
              <a:ext cx="346612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411734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2" name="グラフ 161">
            <a:extLst>
              <a:ext uri="{FF2B5EF4-FFF2-40B4-BE49-F238E27FC236}">
                <a16:creationId xmlns:a16="http://schemas.microsoft.com/office/drawing/2014/main" xmlns="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7081186"/>
              </p:ext>
            </p:extLst>
          </p:nvPr>
        </p:nvGraphicFramePr>
        <p:xfrm>
          <a:off x="2435125" y="5160819"/>
          <a:ext cx="2175198" cy="14544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58" name="グラフ 157">
            <a:extLst>
              <a:ext uri="{FF2B5EF4-FFF2-40B4-BE49-F238E27FC236}">
                <a16:creationId xmlns:a16="http://schemas.microsoft.com/office/drawing/2014/main" xmlns="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4992489"/>
              </p:ext>
            </p:extLst>
          </p:nvPr>
        </p:nvGraphicFramePr>
        <p:xfrm>
          <a:off x="84385" y="5167331"/>
          <a:ext cx="2184945" cy="14542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54" name="グラフ 153">
            <a:extLst>
              <a:ext uri="{FF2B5EF4-FFF2-40B4-BE49-F238E27FC236}">
                <a16:creationId xmlns:a16="http://schemas.microsoft.com/office/drawing/2014/main" xmlns="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9285702"/>
              </p:ext>
            </p:extLst>
          </p:nvPr>
        </p:nvGraphicFramePr>
        <p:xfrm>
          <a:off x="4520837" y="3101665"/>
          <a:ext cx="2161086" cy="14235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6" name="グラフ 95">
            <a:extLst>
              <a:ext uri="{FF2B5EF4-FFF2-40B4-BE49-F238E27FC236}">
                <a16:creationId xmlns:a16="http://schemas.microsoft.com/office/drawing/2014/main" xmlns="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6940953"/>
              </p:ext>
            </p:extLst>
          </p:nvPr>
        </p:nvGraphicFramePr>
        <p:xfrm>
          <a:off x="2250354" y="3072859"/>
          <a:ext cx="2267425" cy="14479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0" name="グラフ 79">
            <a:extLst>
              <a:ext uri="{FF2B5EF4-FFF2-40B4-BE49-F238E27FC236}">
                <a16:creationId xmlns:a16="http://schemas.microsoft.com/office/drawing/2014/main" xmlns="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48515202"/>
              </p:ext>
            </p:extLst>
          </p:nvPr>
        </p:nvGraphicFramePr>
        <p:xfrm>
          <a:off x="35423" y="3101665"/>
          <a:ext cx="2293090" cy="14071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39" name="グラフ 138">
            <a:extLst>
              <a:ext uri="{FF2B5EF4-FFF2-40B4-BE49-F238E27FC236}">
                <a16:creationId xmlns:a16="http://schemas.microsoft.com/office/drawing/2014/main" xmlns="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0110158"/>
              </p:ext>
            </p:extLst>
          </p:nvPr>
        </p:nvGraphicFramePr>
        <p:xfrm>
          <a:off x="764344" y="594485"/>
          <a:ext cx="4925415" cy="19896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7A9A3BE7-6845-4E9E-97C7-63FD6C46BF46}"/>
              </a:ext>
            </a:extLst>
          </p:cNvPr>
          <p:cNvSpPr txBox="1"/>
          <p:nvPr/>
        </p:nvSpPr>
        <p:spPr>
          <a:xfrm>
            <a:off x="49422" y="12355"/>
            <a:ext cx="16417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D0F39807-BCEB-4736-93E6-3D7D23718DE1}"/>
              </a:ext>
            </a:extLst>
          </p:cNvPr>
          <p:cNvSpPr txBox="1"/>
          <p:nvPr/>
        </p:nvSpPr>
        <p:spPr>
          <a:xfrm>
            <a:off x="201822" y="404243"/>
            <a:ext cx="3225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 useBgFill="1">
        <p:nvSpPr>
          <p:cNvPr id="8" name="テキスト ボックス 199">
            <a:extLst>
              <a:ext uri="{FF2B5EF4-FFF2-40B4-BE49-F238E27FC236}">
                <a16:creationId xmlns:a16="http://schemas.microsoft.com/office/drawing/2014/main" xmlns="" id="{1EE5350D-88C5-45DD-AC57-F168709AFF3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40048" y="1381858"/>
            <a:ext cx="1595885" cy="246221"/>
          </a:xfrm>
          <a:prstGeom prst="rect">
            <a:avLst/>
          </a:prstGeom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9700">
                <a:solidFill>
                  <a:schemeClr val="tx1"/>
                </a:solidFill>
                <a:latin typeface="Times New Roman" pitchFamily="18" charset="0"/>
              </a:defRPr>
            </a:lvl1pPr>
            <a:lvl2pPr marL="742950" indent="-285750">
              <a:spcBef>
                <a:spcPct val="20000"/>
              </a:spcBef>
              <a:buChar char="–"/>
              <a:defRPr sz="8500">
                <a:solidFill>
                  <a:schemeClr val="tx1"/>
                </a:solidFill>
                <a:latin typeface="Times New Roman" pitchFamily="18" charset="0"/>
              </a:defRPr>
            </a:lvl2pPr>
            <a:lvl3pPr marL="1143000" indent="-228600">
              <a:spcBef>
                <a:spcPct val="20000"/>
              </a:spcBef>
              <a:buChar char="•"/>
              <a:defRPr sz="7300">
                <a:solidFill>
                  <a:schemeClr val="tx1"/>
                </a:solidFill>
                <a:latin typeface="Times New Roman" pitchFamily="18" charset="0"/>
              </a:defRPr>
            </a:lvl3pPr>
            <a:lvl4pPr marL="1600200" indent="-228600">
              <a:spcBef>
                <a:spcPct val="20000"/>
              </a:spcBef>
              <a:buChar char="–"/>
              <a:defRPr sz="6100">
                <a:solidFill>
                  <a:schemeClr val="tx1"/>
                </a:solidFill>
                <a:latin typeface="Times New Roman" pitchFamily="18" charset="0"/>
              </a:defRPr>
            </a:lvl4pPr>
            <a:lvl5pPr marL="2057400" indent="-228600">
              <a:spcBef>
                <a:spcPct val="20000"/>
              </a:spcBef>
              <a:buChar char="»"/>
              <a:defRPr sz="6100">
                <a:solidFill>
                  <a:schemeClr val="tx1"/>
                </a:solidFill>
                <a:latin typeface="Times New Roman" pitchFamily="18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Times New Roman" pitchFamily="18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Times New Roman" pitchFamily="18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Times New Roman" pitchFamily="18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6100">
                <a:solidFill>
                  <a:schemeClr val="tx1"/>
                </a:solidFill>
                <a:latin typeface="Times New Roman" pitchFamily="18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000" dirty="0">
                <a:ea typeface="ＭＳ Ｐゴシック" panose="020B0600070205080204" pitchFamily="50" charset="-128"/>
                <a:cs typeface="Times New Roman" panose="02020603050405020304" pitchFamily="18" charset="0"/>
              </a:rPr>
              <a:t>Cell number (x 10</a:t>
            </a:r>
            <a:r>
              <a:rPr lang="en-US" altLang="ja-JP" sz="1000" baseline="30000" dirty="0">
                <a:ea typeface="ＭＳ Ｐゴシック" panose="020B0600070205080204" pitchFamily="50" charset="-128"/>
                <a:cs typeface="Times New Roman" panose="02020603050405020304" pitchFamily="18" charset="0"/>
              </a:rPr>
              <a:t>4 </a:t>
            </a:r>
            <a:r>
              <a:rPr lang="en-US" altLang="ja-JP" sz="1000" dirty="0">
                <a:ea typeface="ＭＳ Ｐゴシック" panose="020B0600070205080204" pitchFamily="50" charset="-128"/>
                <a:cs typeface="Times New Roman" panose="02020603050405020304" pitchFamily="18" charset="0"/>
              </a:rPr>
              <a:t>/ ml)</a:t>
            </a:r>
            <a:endParaRPr lang="ja-JP" altLang="en-US" sz="1000" dirty="0"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xmlns="" id="{64411178-0C82-4113-BEF6-167F8C16D071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40" b="24139"/>
          <a:stretch/>
        </p:blipFill>
        <p:spPr>
          <a:xfrm>
            <a:off x="2607921" y="686734"/>
            <a:ext cx="155998" cy="453194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xmlns="" id="{145D37B9-8A5C-49A8-A1ED-B7A61F462572}"/>
              </a:ext>
            </a:extLst>
          </p:cNvPr>
          <p:cNvSpPr txBox="1"/>
          <p:nvPr/>
        </p:nvSpPr>
        <p:spPr>
          <a:xfrm>
            <a:off x="2685620" y="634874"/>
            <a:ext cx="1005403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M</a:t>
            </a:r>
          </a:p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DM-poly(I:C)</a:t>
            </a: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xmlns="" id="{01AD1A6B-DD15-4379-9724-91BBD0D45BC6}"/>
              </a:ext>
            </a:extLst>
          </p:cNvPr>
          <p:cNvSpPr txBox="1"/>
          <p:nvPr/>
        </p:nvSpPr>
        <p:spPr>
          <a:xfrm>
            <a:off x="5292822" y="12355"/>
            <a:ext cx="13035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adamatsu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 et al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xmlns="" id="{BE8078FA-3429-4083-BEE3-5D7756999732}"/>
              </a:ext>
            </a:extLst>
          </p:cNvPr>
          <p:cNvGrpSpPr/>
          <p:nvPr/>
        </p:nvGrpSpPr>
        <p:grpSpPr>
          <a:xfrm>
            <a:off x="1586260" y="425153"/>
            <a:ext cx="328388" cy="267460"/>
            <a:chOff x="1605310" y="434678"/>
            <a:chExt cx="328388" cy="267460"/>
          </a:xfrm>
        </p:grpSpPr>
        <p:sp>
          <p:nvSpPr>
            <p:cNvPr id="52" name="テキスト ボックス 214">
              <a:extLst>
                <a:ext uri="{FF2B5EF4-FFF2-40B4-BE49-F238E27FC236}">
                  <a16:creationId xmlns:a16="http://schemas.microsoft.com/office/drawing/2014/main" xmlns="" id="{90923BA8-B786-472D-8E05-9360AC99B1E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13792" y="434678"/>
              <a:ext cx="3199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3" name="フリーフォーム 92">
              <a:extLst>
                <a:ext uri="{FF2B5EF4-FFF2-40B4-BE49-F238E27FC236}">
                  <a16:creationId xmlns:a16="http://schemas.microsoft.com/office/drawing/2014/main" xmlns="" id="{88ECBCA6-CA60-4E91-A380-76AC6678C332}"/>
                </a:ext>
              </a:extLst>
            </p:cNvPr>
            <p:cNvSpPr/>
            <p:nvPr/>
          </p:nvSpPr>
          <p:spPr>
            <a:xfrm>
              <a:off x="1605310" y="628064"/>
              <a:ext cx="319905" cy="74074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xmlns="" id="{FFB3ADDA-EA91-4E56-88BC-C869EECFEBD2}"/>
              </a:ext>
            </a:extLst>
          </p:cNvPr>
          <p:cNvSpPr txBox="1"/>
          <p:nvPr/>
        </p:nvSpPr>
        <p:spPr>
          <a:xfrm>
            <a:off x="90634" y="3149128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g</a:t>
            </a:r>
            <a:r>
              <a:rPr lang="en-US" altLang="ja-JP" sz="1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</a:t>
            </a:r>
            <a:endParaRPr lang="ja-JP" altLang="en-US" sz="10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xmlns="" id="{B90EF2C6-8D9C-42EA-A46E-DEE1EB5F8D98}"/>
              </a:ext>
            </a:extLst>
          </p:cNvPr>
          <p:cNvSpPr txBox="1"/>
          <p:nvPr/>
        </p:nvSpPr>
        <p:spPr>
          <a:xfrm>
            <a:off x="4925481" y="6031456"/>
            <a:ext cx="59663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* p&lt;0.05</a:t>
            </a: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xmlns="" id="{4A037BD1-3C30-4DB1-BB1F-D5F6429EC496}"/>
              </a:ext>
            </a:extLst>
          </p:cNvPr>
          <p:cNvSpPr txBox="1"/>
          <p:nvPr/>
        </p:nvSpPr>
        <p:spPr>
          <a:xfrm>
            <a:off x="159563" y="2841351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xmlns="" id="{496985C1-3DD9-4AEB-9872-A7CC169888A1}"/>
              </a:ext>
            </a:extLst>
          </p:cNvPr>
          <p:cNvSpPr txBox="1"/>
          <p:nvPr/>
        </p:nvSpPr>
        <p:spPr>
          <a:xfrm>
            <a:off x="2269330" y="2841350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xmlns="" id="{20ADF5DC-D388-4D26-94AE-2C7E6F823620}"/>
              </a:ext>
            </a:extLst>
          </p:cNvPr>
          <p:cNvSpPr txBox="1"/>
          <p:nvPr/>
        </p:nvSpPr>
        <p:spPr>
          <a:xfrm>
            <a:off x="4505585" y="2841350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xmlns="" id="{594A0008-FB55-417C-A3B4-ED83D6F93FAF}"/>
              </a:ext>
            </a:extLst>
          </p:cNvPr>
          <p:cNvSpPr txBox="1"/>
          <p:nvPr/>
        </p:nvSpPr>
        <p:spPr>
          <a:xfrm>
            <a:off x="180531" y="4945146"/>
            <a:ext cx="3177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xmlns="" id="{60E9EF8E-71BD-4202-B8C7-7F2BBF65655E}"/>
              </a:ext>
            </a:extLst>
          </p:cNvPr>
          <p:cNvSpPr txBox="1"/>
          <p:nvPr/>
        </p:nvSpPr>
        <p:spPr>
          <a:xfrm>
            <a:off x="2507271" y="4945145"/>
            <a:ext cx="2957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xmlns="" id="{96B8A458-5C20-48FB-B377-45E2C5FDFC1D}"/>
              </a:ext>
            </a:extLst>
          </p:cNvPr>
          <p:cNvSpPr txBox="1"/>
          <p:nvPr/>
        </p:nvSpPr>
        <p:spPr>
          <a:xfrm>
            <a:off x="386664" y="4414835"/>
            <a:ext cx="18549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trol           HDM          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DM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poly(I:C)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xmlns="" id="{6A2FFE78-3160-4C70-9EB6-0C586127E176}"/>
              </a:ext>
            </a:extLst>
          </p:cNvPr>
          <p:cNvSpPr txBox="1"/>
          <p:nvPr/>
        </p:nvSpPr>
        <p:spPr>
          <a:xfrm>
            <a:off x="2493068" y="4413114"/>
            <a:ext cx="1912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control           HDM         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DM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poly(I:C)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xmlns="" id="{C638109F-1414-4501-BD5D-15CF69CEDA51}"/>
              </a:ext>
            </a:extLst>
          </p:cNvPr>
          <p:cNvSpPr txBox="1"/>
          <p:nvPr/>
        </p:nvSpPr>
        <p:spPr>
          <a:xfrm>
            <a:off x="4724118" y="4413114"/>
            <a:ext cx="19127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control          HDM          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DM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  poly(I:C)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xmlns="" id="{F133A0E4-CDCB-4357-988C-A71C320C8799}"/>
              </a:ext>
            </a:extLst>
          </p:cNvPr>
          <p:cNvSpPr txBox="1"/>
          <p:nvPr/>
        </p:nvSpPr>
        <p:spPr>
          <a:xfrm>
            <a:off x="345513" y="6518006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control         HDM         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DM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poly(I:C)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xmlns="" id="{F0AD0903-BAA8-4059-BEDA-0E7A71783CCC}"/>
              </a:ext>
            </a:extLst>
          </p:cNvPr>
          <p:cNvSpPr txBox="1"/>
          <p:nvPr/>
        </p:nvSpPr>
        <p:spPr>
          <a:xfrm>
            <a:off x="2699335" y="6518006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control         HDM          </a:t>
            </a:r>
            <a:r>
              <a:rPr kumimoji="1" lang="en-US" altLang="ja-JP" sz="9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DM</a:t>
            </a:r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</a:p>
          <a:p>
            <a:r>
              <a:rPr kumimoji="1"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poly(I:C)</a:t>
            </a:r>
            <a:endParaRPr kumimoji="1"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:a16="http://schemas.microsoft.com/office/drawing/2014/main" xmlns="" id="{026A29F5-2CA2-458F-AE72-24C1AE5B36CF}"/>
              </a:ext>
            </a:extLst>
          </p:cNvPr>
          <p:cNvSpPr txBox="1"/>
          <p:nvPr/>
        </p:nvSpPr>
        <p:spPr>
          <a:xfrm>
            <a:off x="2226237" y="3153981"/>
            <a:ext cx="4972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 err="1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g</a:t>
            </a:r>
            <a:r>
              <a:rPr lang="en-US" altLang="ja-JP" sz="1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</a:t>
            </a:r>
            <a:endParaRPr lang="ja-JP" altLang="en-US" sz="10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xmlns="" id="{70370D74-EC20-49E5-8637-0B4BE6E43F6A}"/>
              </a:ext>
            </a:extLst>
          </p:cNvPr>
          <p:cNvSpPr txBox="1"/>
          <p:nvPr/>
        </p:nvSpPr>
        <p:spPr>
          <a:xfrm>
            <a:off x="137179" y="5246999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g</a:t>
            </a:r>
            <a:r>
              <a:rPr lang="en-US" altLang="ja-JP" sz="1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</a:t>
            </a:r>
            <a:endParaRPr lang="ja-JP" altLang="en-US" sz="10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xmlns="" id="{F143A70E-CC9E-4AAB-BD5B-A6BC1765ADD6}"/>
              </a:ext>
            </a:extLst>
          </p:cNvPr>
          <p:cNvSpPr txBox="1"/>
          <p:nvPr/>
        </p:nvSpPr>
        <p:spPr>
          <a:xfrm>
            <a:off x="2477600" y="5251546"/>
            <a:ext cx="4972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 err="1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pg</a:t>
            </a:r>
            <a:r>
              <a:rPr lang="en-US" altLang="ja-JP" sz="1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ml</a:t>
            </a:r>
            <a:endParaRPr lang="ja-JP" altLang="en-US" sz="10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xmlns="" id="{F6554C9B-96F4-4B28-ABD9-BA334AD7D3BE}"/>
              </a:ext>
            </a:extLst>
          </p:cNvPr>
          <p:cNvSpPr txBox="1"/>
          <p:nvPr/>
        </p:nvSpPr>
        <p:spPr>
          <a:xfrm>
            <a:off x="4439620" y="3145737"/>
            <a:ext cx="4972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ng/ml</a:t>
            </a:r>
            <a:endParaRPr lang="ja-JP" altLang="en-US" sz="10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xmlns="" id="{BEDC90B6-C48A-420D-80EF-A4ABBE8525A8}"/>
              </a:ext>
            </a:extLst>
          </p:cNvPr>
          <p:cNvGrpSpPr/>
          <p:nvPr/>
        </p:nvGrpSpPr>
        <p:grpSpPr>
          <a:xfrm>
            <a:off x="1215576" y="3257790"/>
            <a:ext cx="725624" cy="298143"/>
            <a:chOff x="1215576" y="3257790"/>
            <a:chExt cx="725624" cy="298143"/>
          </a:xfrm>
        </p:grpSpPr>
        <p:sp>
          <p:nvSpPr>
            <p:cNvPr id="100" name="テキスト ボックス 214">
              <a:extLst>
                <a:ext uri="{FF2B5EF4-FFF2-40B4-BE49-F238E27FC236}">
                  <a16:creationId xmlns:a16="http://schemas.microsoft.com/office/drawing/2014/main" xmlns="" id="{602CAE8B-34F9-4D1E-83B2-441CEBCA707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40972" y="3257790"/>
              <a:ext cx="3134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2" name="フリーフォーム 56">
              <a:extLst>
                <a:ext uri="{FF2B5EF4-FFF2-40B4-BE49-F238E27FC236}">
                  <a16:creationId xmlns:a16="http://schemas.microsoft.com/office/drawing/2014/main" xmlns="" id="{E844558B-296C-4FF8-B5F0-05FABF454A8E}"/>
                </a:ext>
              </a:extLst>
            </p:cNvPr>
            <p:cNvSpPr/>
            <p:nvPr/>
          </p:nvSpPr>
          <p:spPr>
            <a:xfrm>
              <a:off x="1215576" y="3459356"/>
              <a:ext cx="725624" cy="96577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40" name="グループ化 139">
            <a:extLst>
              <a:ext uri="{FF2B5EF4-FFF2-40B4-BE49-F238E27FC236}">
                <a16:creationId xmlns:a16="http://schemas.microsoft.com/office/drawing/2014/main" xmlns="" id="{580D6780-387F-4F1C-861C-CE22B420B96D}"/>
              </a:ext>
            </a:extLst>
          </p:cNvPr>
          <p:cNvGrpSpPr/>
          <p:nvPr/>
        </p:nvGrpSpPr>
        <p:grpSpPr>
          <a:xfrm>
            <a:off x="4240145" y="975104"/>
            <a:ext cx="328388" cy="267460"/>
            <a:chOff x="1605310" y="434678"/>
            <a:chExt cx="328388" cy="267460"/>
          </a:xfrm>
        </p:grpSpPr>
        <p:sp>
          <p:nvSpPr>
            <p:cNvPr id="141" name="テキスト ボックス 214">
              <a:extLst>
                <a:ext uri="{FF2B5EF4-FFF2-40B4-BE49-F238E27FC236}">
                  <a16:creationId xmlns:a16="http://schemas.microsoft.com/office/drawing/2014/main" xmlns="" id="{07FFC2F2-96E7-4067-95C8-7D4347CBD09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13792" y="434678"/>
              <a:ext cx="3199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2" name="フリーフォーム 92">
              <a:extLst>
                <a:ext uri="{FF2B5EF4-FFF2-40B4-BE49-F238E27FC236}">
                  <a16:creationId xmlns:a16="http://schemas.microsoft.com/office/drawing/2014/main" xmlns="" id="{4C3235D4-0F4E-49B9-AB87-DA8EB9C40ED8}"/>
                </a:ext>
              </a:extLst>
            </p:cNvPr>
            <p:cNvSpPr/>
            <p:nvPr/>
          </p:nvSpPr>
          <p:spPr>
            <a:xfrm>
              <a:off x="1605310" y="628064"/>
              <a:ext cx="319905" cy="74074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43" name="グループ化 142">
            <a:extLst>
              <a:ext uri="{FF2B5EF4-FFF2-40B4-BE49-F238E27FC236}">
                <a16:creationId xmlns:a16="http://schemas.microsoft.com/office/drawing/2014/main" xmlns="" id="{FB6A4D6D-D4E1-4644-85CE-1A6BA305047D}"/>
              </a:ext>
            </a:extLst>
          </p:cNvPr>
          <p:cNvGrpSpPr/>
          <p:nvPr/>
        </p:nvGrpSpPr>
        <p:grpSpPr>
          <a:xfrm>
            <a:off x="2493068" y="1780140"/>
            <a:ext cx="319906" cy="251057"/>
            <a:chOff x="1626223" y="451080"/>
            <a:chExt cx="319906" cy="251057"/>
          </a:xfrm>
        </p:grpSpPr>
        <p:sp>
          <p:nvSpPr>
            <p:cNvPr id="144" name="テキスト ボックス 214">
              <a:extLst>
                <a:ext uri="{FF2B5EF4-FFF2-40B4-BE49-F238E27FC236}">
                  <a16:creationId xmlns:a16="http://schemas.microsoft.com/office/drawing/2014/main" xmlns="" id="{1AE4B1E5-8667-4D87-8B83-E09F1A05588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26223" y="451080"/>
              <a:ext cx="3199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9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**</a:t>
              </a:r>
              <a:endParaRPr lang="ja-JP" altLang="en-US" sz="9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5" name="フリーフォーム 92">
              <a:extLst>
                <a:ext uri="{FF2B5EF4-FFF2-40B4-BE49-F238E27FC236}">
                  <a16:creationId xmlns:a16="http://schemas.microsoft.com/office/drawing/2014/main" xmlns="" id="{63AB4A2E-C28B-4BEF-99D3-603EBD1F047E}"/>
                </a:ext>
              </a:extLst>
            </p:cNvPr>
            <p:cNvSpPr/>
            <p:nvPr/>
          </p:nvSpPr>
          <p:spPr>
            <a:xfrm>
              <a:off x="1637718" y="632972"/>
              <a:ext cx="287497" cy="69165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46" name="グループ化 145">
            <a:extLst>
              <a:ext uri="{FF2B5EF4-FFF2-40B4-BE49-F238E27FC236}">
                <a16:creationId xmlns:a16="http://schemas.microsoft.com/office/drawing/2014/main" xmlns="" id="{BE6F7EF7-2E4C-4F2A-B937-BF4601F6B405}"/>
              </a:ext>
            </a:extLst>
          </p:cNvPr>
          <p:cNvGrpSpPr/>
          <p:nvPr/>
        </p:nvGrpSpPr>
        <p:grpSpPr>
          <a:xfrm>
            <a:off x="3362771" y="1759915"/>
            <a:ext cx="319906" cy="251057"/>
            <a:chOff x="1626223" y="451080"/>
            <a:chExt cx="319906" cy="251057"/>
          </a:xfrm>
        </p:grpSpPr>
        <p:sp>
          <p:nvSpPr>
            <p:cNvPr id="147" name="テキスト ボックス 214">
              <a:extLst>
                <a:ext uri="{FF2B5EF4-FFF2-40B4-BE49-F238E27FC236}">
                  <a16:creationId xmlns:a16="http://schemas.microsoft.com/office/drawing/2014/main" xmlns="" id="{F9D59BEF-58BB-48CA-A34A-BFCFE4D3FED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26223" y="451080"/>
              <a:ext cx="31990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9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**</a:t>
              </a:r>
              <a:endParaRPr lang="ja-JP" altLang="en-US" sz="9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8" name="フリーフォーム 92">
              <a:extLst>
                <a:ext uri="{FF2B5EF4-FFF2-40B4-BE49-F238E27FC236}">
                  <a16:creationId xmlns:a16="http://schemas.microsoft.com/office/drawing/2014/main" xmlns="" id="{AC96039B-20C3-4AA6-B2FB-2F67A747AC17}"/>
                </a:ext>
              </a:extLst>
            </p:cNvPr>
            <p:cNvSpPr/>
            <p:nvPr/>
          </p:nvSpPr>
          <p:spPr>
            <a:xfrm>
              <a:off x="1637718" y="632972"/>
              <a:ext cx="287497" cy="69165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49" name="グループ化 148">
            <a:extLst>
              <a:ext uri="{FF2B5EF4-FFF2-40B4-BE49-F238E27FC236}">
                <a16:creationId xmlns:a16="http://schemas.microsoft.com/office/drawing/2014/main" xmlns="" id="{9542017C-5AAC-40CE-902F-C7FEEA3EFEE1}"/>
              </a:ext>
            </a:extLst>
          </p:cNvPr>
          <p:cNvGrpSpPr/>
          <p:nvPr/>
        </p:nvGrpSpPr>
        <p:grpSpPr>
          <a:xfrm>
            <a:off x="5128628" y="1607871"/>
            <a:ext cx="328388" cy="267460"/>
            <a:chOff x="1605310" y="434678"/>
            <a:chExt cx="328388" cy="267460"/>
          </a:xfrm>
        </p:grpSpPr>
        <p:sp>
          <p:nvSpPr>
            <p:cNvPr id="150" name="テキスト ボックス 214">
              <a:extLst>
                <a:ext uri="{FF2B5EF4-FFF2-40B4-BE49-F238E27FC236}">
                  <a16:creationId xmlns:a16="http://schemas.microsoft.com/office/drawing/2014/main" xmlns="" id="{50817C2C-BDF0-49DC-AC3C-B7122494650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13792" y="434678"/>
              <a:ext cx="319906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51" name="フリーフォーム 92">
              <a:extLst>
                <a:ext uri="{FF2B5EF4-FFF2-40B4-BE49-F238E27FC236}">
                  <a16:creationId xmlns:a16="http://schemas.microsoft.com/office/drawing/2014/main" xmlns="" id="{D59518C7-DDFE-4DB7-8CC7-9570F850118A}"/>
                </a:ext>
              </a:extLst>
            </p:cNvPr>
            <p:cNvSpPr/>
            <p:nvPr/>
          </p:nvSpPr>
          <p:spPr>
            <a:xfrm>
              <a:off x="1605310" y="628064"/>
              <a:ext cx="319905" cy="74074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38" name="グループ化 137">
            <a:extLst>
              <a:ext uri="{FF2B5EF4-FFF2-40B4-BE49-F238E27FC236}">
                <a16:creationId xmlns:a16="http://schemas.microsoft.com/office/drawing/2014/main" xmlns="" id="{205D510B-6C30-4A69-88E7-58190DBEF8DF}"/>
              </a:ext>
            </a:extLst>
          </p:cNvPr>
          <p:cNvGrpSpPr/>
          <p:nvPr/>
        </p:nvGrpSpPr>
        <p:grpSpPr>
          <a:xfrm>
            <a:off x="3384066" y="3331110"/>
            <a:ext cx="725624" cy="298143"/>
            <a:chOff x="1215576" y="3257790"/>
            <a:chExt cx="725624" cy="298143"/>
          </a:xfrm>
        </p:grpSpPr>
        <p:sp>
          <p:nvSpPr>
            <p:cNvPr id="152" name="テキスト ボックス 214">
              <a:extLst>
                <a:ext uri="{FF2B5EF4-FFF2-40B4-BE49-F238E27FC236}">
                  <a16:creationId xmlns:a16="http://schemas.microsoft.com/office/drawing/2014/main" xmlns="" id="{4614532C-BCB8-4E01-9934-9427B2445E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40972" y="3257790"/>
              <a:ext cx="3134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53" name="フリーフォーム 56">
              <a:extLst>
                <a:ext uri="{FF2B5EF4-FFF2-40B4-BE49-F238E27FC236}">
                  <a16:creationId xmlns:a16="http://schemas.microsoft.com/office/drawing/2014/main" xmlns="" id="{C8AD2927-C1D2-4A99-9582-D05B971972BC}"/>
                </a:ext>
              </a:extLst>
            </p:cNvPr>
            <p:cNvSpPr/>
            <p:nvPr/>
          </p:nvSpPr>
          <p:spPr>
            <a:xfrm>
              <a:off x="1215576" y="3459356"/>
              <a:ext cx="725624" cy="96577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55" name="グループ化 154">
            <a:extLst>
              <a:ext uri="{FF2B5EF4-FFF2-40B4-BE49-F238E27FC236}">
                <a16:creationId xmlns:a16="http://schemas.microsoft.com/office/drawing/2014/main" xmlns="" id="{403B118A-5254-4B9B-BE01-6F8ABAE80836}"/>
              </a:ext>
            </a:extLst>
          </p:cNvPr>
          <p:cNvGrpSpPr/>
          <p:nvPr/>
        </p:nvGrpSpPr>
        <p:grpSpPr>
          <a:xfrm>
            <a:off x="5579827" y="3471522"/>
            <a:ext cx="725624" cy="298143"/>
            <a:chOff x="1215576" y="3257790"/>
            <a:chExt cx="725624" cy="298143"/>
          </a:xfrm>
        </p:grpSpPr>
        <p:sp>
          <p:nvSpPr>
            <p:cNvPr id="156" name="テキスト ボックス 214">
              <a:extLst>
                <a:ext uri="{FF2B5EF4-FFF2-40B4-BE49-F238E27FC236}">
                  <a16:creationId xmlns:a16="http://schemas.microsoft.com/office/drawing/2014/main" xmlns="" id="{CD4E5759-1065-4F79-A60E-91D62541981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40972" y="3257790"/>
              <a:ext cx="3134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57" name="フリーフォーム 56">
              <a:extLst>
                <a:ext uri="{FF2B5EF4-FFF2-40B4-BE49-F238E27FC236}">
                  <a16:creationId xmlns:a16="http://schemas.microsoft.com/office/drawing/2014/main" xmlns="" id="{8A0F475C-99BB-47FD-8E6A-F90B45E95D5E}"/>
                </a:ext>
              </a:extLst>
            </p:cNvPr>
            <p:cNvSpPr/>
            <p:nvPr/>
          </p:nvSpPr>
          <p:spPr>
            <a:xfrm>
              <a:off x="1215576" y="3459356"/>
              <a:ext cx="725624" cy="96577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59" name="グループ化 158">
            <a:extLst>
              <a:ext uri="{FF2B5EF4-FFF2-40B4-BE49-F238E27FC236}">
                <a16:creationId xmlns:a16="http://schemas.microsoft.com/office/drawing/2014/main" xmlns="" id="{69CBC072-C77F-4E48-9F19-20AAEE84F3B8}"/>
              </a:ext>
            </a:extLst>
          </p:cNvPr>
          <p:cNvGrpSpPr/>
          <p:nvPr/>
        </p:nvGrpSpPr>
        <p:grpSpPr>
          <a:xfrm>
            <a:off x="1193201" y="5369059"/>
            <a:ext cx="725624" cy="298143"/>
            <a:chOff x="1215576" y="3257790"/>
            <a:chExt cx="725624" cy="298143"/>
          </a:xfrm>
        </p:grpSpPr>
        <p:sp>
          <p:nvSpPr>
            <p:cNvPr id="160" name="テキスト ボックス 214">
              <a:extLst>
                <a:ext uri="{FF2B5EF4-FFF2-40B4-BE49-F238E27FC236}">
                  <a16:creationId xmlns:a16="http://schemas.microsoft.com/office/drawing/2014/main" xmlns="" id="{A7095C5E-5D1E-49CD-A0FE-A13C2344B91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40972" y="3257790"/>
              <a:ext cx="3134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800" dirty="0" err="1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n.s</a:t>
              </a:r>
              <a:r>
                <a:rPr lang="en-US" altLang="ja-JP" sz="8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.</a:t>
              </a:r>
              <a:endParaRPr lang="ja-JP" altLang="en-US" sz="8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61" name="フリーフォーム 56">
              <a:extLst>
                <a:ext uri="{FF2B5EF4-FFF2-40B4-BE49-F238E27FC236}">
                  <a16:creationId xmlns:a16="http://schemas.microsoft.com/office/drawing/2014/main" xmlns="" id="{42B28669-58B1-4456-933E-8CE526706B33}"/>
                </a:ext>
              </a:extLst>
            </p:cNvPr>
            <p:cNvSpPr/>
            <p:nvPr/>
          </p:nvSpPr>
          <p:spPr>
            <a:xfrm>
              <a:off x="1215576" y="3459356"/>
              <a:ext cx="725624" cy="96577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163" name="グループ化 162">
            <a:extLst>
              <a:ext uri="{FF2B5EF4-FFF2-40B4-BE49-F238E27FC236}">
                <a16:creationId xmlns:a16="http://schemas.microsoft.com/office/drawing/2014/main" xmlns="" id="{F022B70A-675A-4BF8-9449-A904ABFE7181}"/>
              </a:ext>
            </a:extLst>
          </p:cNvPr>
          <p:cNvGrpSpPr/>
          <p:nvPr/>
        </p:nvGrpSpPr>
        <p:grpSpPr>
          <a:xfrm>
            <a:off x="3536592" y="5418098"/>
            <a:ext cx="725624" cy="269123"/>
            <a:chOff x="1215576" y="3286810"/>
            <a:chExt cx="725624" cy="269123"/>
          </a:xfrm>
        </p:grpSpPr>
        <p:sp>
          <p:nvSpPr>
            <p:cNvPr id="164" name="テキスト ボックス 214">
              <a:extLst>
                <a:ext uri="{FF2B5EF4-FFF2-40B4-BE49-F238E27FC236}">
                  <a16:creationId xmlns:a16="http://schemas.microsoft.com/office/drawing/2014/main" xmlns="" id="{363153FB-F1A6-4834-9E7E-A625268595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75204" y="3286810"/>
              <a:ext cx="313470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9700">
                  <a:solidFill>
                    <a:schemeClr val="tx1"/>
                  </a:solidFill>
                  <a:latin typeface="Times New Roman" pitchFamily="18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8500">
                  <a:solidFill>
                    <a:schemeClr val="tx1"/>
                  </a:solidFill>
                  <a:latin typeface="Times New Roman" pitchFamily="18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7300">
                  <a:solidFill>
                    <a:schemeClr val="tx1"/>
                  </a:solidFill>
                  <a:latin typeface="Times New Roman" pitchFamily="18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6100">
                  <a:solidFill>
                    <a:schemeClr val="tx1"/>
                  </a:solidFill>
                  <a:latin typeface="Times New Roman" pitchFamily="18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900" dirty="0">
                  <a:ea typeface="ＭＳ Ｐゴシック" panose="020B0600070205080204" pitchFamily="50" charset="-128"/>
                  <a:cs typeface="Times New Roman" panose="02020603050405020304" pitchFamily="18" charset="0"/>
                </a:rPr>
                <a:t>*</a:t>
              </a:r>
              <a:endParaRPr lang="ja-JP" altLang="en-US" sz="900" dirty="0">
                <a:ea typeface="ＭＳ Ｐゴシック" panose="020B060007020508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65" name="フリーフォーム 56">
              <a:extLst>
                <a:ext uri="{FF2B5EF4-FFF2-40B4-BE49-F238E27FC236}">
                  <a16:creationId xmlns:a16="http://schemas.microsoft.com/office/drawing/2014/main" xmlns="" id="{74C71EBA-4B21-4682-93CB-C12DAD2509F2}"/>
                </a:ext>
              </a:extLst>
            </p:cNvPr>
            <p:cNvSpPr/>
            <p:nvPr/>
          </p:nvSpPr>
          <p:spPr>
            <a:xfrm>
              <a:off x="1215576" y="3459356"/>
              <a:ext cx="725624" cy="96577"/>
            </a:xfrm>
            <a:custGeom>
              <a:avLst/>
              <a:gdLst>
                <a:gd name="connsiteX0" fmla="*/ 0 w 1078301"/>
                <a:gd name="connsiteY0" fmla="*/ 284672 h 284672"/>
                <a:gd name="connsiteX1" fmla="*/ 0 w 1078301"/>
                <a:gd name="connsiteY1" fmla="*/ 0 h 284672"/>
                <a:gd name="connsiteX2" fmla="*/ 1078301 w 1078301"/>
                <a:gd name="connsiteY2" fmla="*/ 0 h 284672"/>
                <a:gd name="connsiteX3" fmla="*/ 1078301 w 1078301"/>
                <a:gd name="connsiteY3" fmla="*/ 267419 h 28467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1078301" h="284672">
                  <a:moveTo>
                    <a:pt x="0" y="284672"/>
                  </a:moveTo>
                  <a:lnTo>
                    <a:pt x="0" y="0"/>
                  </a:lnTo>
                  <a:lnTo>
                    <a:pt x="1078301" y="0"/>
                  </a:lnTo>
                  <a:lnTo>
                    <a:pt x="1078301" y="267419"/>
                  </a:lnTo>
                </a:path>
              </a:pathLst>
            </a:cu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66" name="テキスト ボックス 165">
            <a:extLst>
              <a:ext uri="{FF2B5EF4-FFF2-40B4-BE49-F238E27FC236}">
                <a16:creationId xmlns:a16="http://schemas.microsoft.com/office/drawing/2014/main" xmlns="" id="{41674EA5-9DD0-491F-B6A5-3032989A339B}"/>
              </a:ext>
            </a:extLst>
          </p:cNvPr>
          <p:cNvSpPr txBox="1"/>
          <p:nvPr/>
        </p:nvSpPr>
        <p:spPr>
          <a:xfrm>
            <a:off x="4801455" y="512648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** p&lt;0.01</a:t>
            </a:r>
          </a:p>
        </p:txBody>
      </p:sp>
    </p:spTree>
    <p:extLst>
      <p:ext uri="{BB962C8B-B14F-4D97-AF65-F5344CB8AC3E}">
        <p14:creationId xmlns:p14="http://schemas.microsoft.com/office/powerpoint/2010/main" val="641784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7</TotalTime>
  <Words>244</Words>
  <Application>Microsoft Office PowerPoint</Application>
  <PresentationFormat>A4 Paper (210x297 mm)</PresentationFormat>
  <Paragraphs>10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10" baseType="lpstr">
      <vt:lpstr>ＭＳ Ｐゴシック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ichiro Takahashi</dc:creator>
  <cp:lastModifiedBy>Suganthi B.</cp:lastModifiedBy>
  <cp:revision>184</cp:revision>
  <cp:lastPrinted>2019-04-30T08:58:17Z</cp:lastPrinted>
  <dcterms:created xsi:type="dcterms:W3CDTF">2018-08-16T01:02:27Z</dcterms:created>
  <dcterms:modified xsi:type="dcterms:W3CDTF">2019-12-05T08:33:25Z</dcterms:modified>
</cp:coreProperties>
</file>